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6" r:id="rId2"/>
    <p:sldId id="269" r:id="rId3"/>
    <p:sldId id="270" r:id="rId4"/>
    <p:sldId id="271" r:id="rId5"/>
    <p:sldId id="272" r:id="rId6"/>
    <p:sldId id="267" r:id="rId7"/>
    <p:sldId id="273" r:id="rId8"/>
    <p:sldId id="274" r:id="rId9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CDCFA714-74EF-2190-E9F2-BA52A4FA5722}" name="SAMUEL FERNANDEZ TOME" initials="SFT" userId="SAMUEL FERNANDEZ TOME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632" autoAdjust="0"/>
    <p:restoredTop sz="94269" autoAdjust="0"/>
  </p:normalViewPr>
  <p:slideViewPr>
    <p:cSldViewPr snapToGrid="0">
      <p:cViewPr>
        <p:scale>
          <a:sx n="100" d="100"/>
          <a:sy n="100" d="100"/>
        </p:scale>
        <p:origin x="348" y="-13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microsoft.com/office/2018/10/relationships/authors" Target="author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782271-B7BD-4345-9889-00AE917E245D}" type="datetimeFigureOut">
              <a:rPr lang="en-US" smtClean="0"/>
              <a:t>8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251D57-BE29-4B29-86C0-F4D4C46D19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91887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782271-B7BD-4345-9889-00AE917E245D}" type="datetimeFigureOut">
              <a:rPr lang="en-US" smtClean="0"/>
              <a:t>8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251D57-BE29-4B29-86C0-F4D4C46D19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29316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782271-B7BD-4345-9889-00AE917E245D}" type="datetimeFigureOut">
              <a:rPr lang="en-US" smtClean="0"/>
              <a:t>8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251D57-BE29-4B29-86C0-F4D4C46D19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81173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782271-B7BD-4345-9889-00AE917E245D}" type="datetimeFigureOut">
              <a:rPr lang="en-US" smtClean="0"/>
              <a:t>8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251D57-BE29-4B29-86C0-F4D4C46D19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8813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782271-B7BD-4345-9889-00AE917E245D}" type="datetimeFigureOut">
              <a:rPr lang="en-US" smtClean="0"/>
              <a:t>8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251D57-BE29-4B29-86C0-F4D4C46D19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64139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782271-B7BD-4345-9889-00AE917E245D}" type="datetimeFigureOut">
              <a:rPr lang="en-US" smtClean="0"/>
              <a:t>8/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251D57-BE29-4B29-86C0-F4D4C46D19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51220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782271-B7BD-4345-9889-00AE917E245D}" type="datetimeFigureOut">
              <a:rPr lang="en-US" smtClean="0"/>
              <a:t>8/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251D57-BE29-4B29-86C0-F4D4C46D19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42750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782271-B7BD-4345-9889-00AE917E245D}" type="datetimeFigureOut">
              <a:rPr lang="en-US" smtClean="0"/>
              <a:t>8/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251D57-BE29-4B29-86C0-F4D4C46D19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35439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782271-B7BD-4345-9889-00AE917E245D}" type="datetimeFigureOut">
              <a:rPr lang="en-US" smtClean="0"/>
              <a:t>8/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251D57-BE29-4B29-86C0-F4D4C46D19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79404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782271-B7BD-4345-9889-00AE917E245D}" type="datetimeFigureOut">
              <a:rPr lang="en-US" smtClean="0"/>
              <a:t>8/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251D57-BE29-4B29-86C0-F4D4C46D19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32649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782271-B7BD-4345-9889-00AE917E245D}" type="datetimeFigureOut">
              <a:rPr lang="en-US" smtClean="0"/>
              <a:t>8/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251D57-BE29-4B29-86C0-F4D4C46D19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55941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782271-B7BD-4345-9889-00AE917E245D}" type="datetimeFigureOut">
              <a:rPr lang="en-US" smtClean="0"/>
              <a:t>8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251D57-BE29-4B29-86C0-F4D4C46D19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03979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2" Type="http://schemas.openxmlformats.org/officeDocument/2006/relationships/image" Target="../media/image1.emf"/><Relationship Id="rId16" Type="http://schemas.openxmlformats.org/officeDocument/2006/relationships/image" Target="../media/image15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5" Type="http://schemas.openxmlformats.org/officeDocument/2006/relationships/image" Target="../media/image1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Relationship Id="rId14" Type="http://schemas.openxmlformats.org/officeDocument/2006/relationships/image" Target="../media/image13.em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emf"/><Relationship Id="rId13" Type="http://schemas.openxmlformats.org/officeDocument/2006/relationships/image" Target="../media/image27.emf"/><Relationship Id="rId3" Type="http://schemas.openxmlformats.org/officeDocument/2006/relationships/image" Target="../media/image17.emf"/><Relationship Id="rId7" Type="http://schemas.openxmlformats.org/officeDocument/2006/relationships/image" Target="../media/image21.emf"/><Relationship Id="rId12" Type="http://schemas.openxmlformats.org/officeDocument/2006/relationships/image" Target="../media/image26.emf"/><Relationship Id="rId2" Type="http://schemas.openxmlformats.org/officeDocument/2006/relationships/image" Target="../media/image16.emf"/><Relationship Id="rId16" Type="http://schemas.openxmlformats.org/officeDocument/2006/relationships/image" Target="../media/image30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emf"/><Relationship Id="rId11" Type="http://schemas.openxmlformats.org/officeDocument/2006/relationships/image" Target="../media/image25.emf"/><Relationship Id="rId5" Type="http://schemas.openxmlformats.org/officeDocument/2006/relationships/image" Target="../media/image19.emf"/><Relationship Id="rId15" Type="http://schemas.openxmlformats.org/officeDocument/2006/relationships/image" Target="../media/image29.emf"/><Relationship Id="rId10" Type="http://schemas.openxmlformats.org/officeDocument/2006/relationships/image" Target="../media/image24.emf"/><Relationship Id="rId4" Type="http://schemas.openxmlformats.org/officeDocument/2006/relationships/image" Target="../media/image18.emf"/><Relationship Id="rId9" Type="http://schemas.openxmlformats.org/officeDocument/2006/relationships/image" Target="../media/image23.emf"/><Relationship Id="rId14" Type="http://schemas.openxmlformats.org/officeDocument/2006/relationships/image" Target="../media/image2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058A5A6D-84A7-4F86-94C5-2E347489ED5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78801270"/>
              </p:ext>
            </p:extLst>
          </p:nvPr>
        </p:nvGraphicFramePr>
        <p:xfrm>
          <a:off x="1903613" y="513147"/>
          <a:ext cx="4833255" cy="432738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966651">
                  <a:extLst>
                    <a:ext uri="{9D8B030D-6E8A-4147-A177-3AD203B41FA5}">
                      <a16:colId xmlns:a16="http://schemas.microsoft.com/office/drawing/2014/main" val="630714373"/>
                    </a:ext>
                  </a:extLst>
                </a:gridCol>
                <a:gridCol w="966651">
                  <a:extLst>
                    <a:ext uri="{9D8B030D-6E8A-4147-A177-3AD203B41FA5}">
                      <a16:colId xmlns:a16="http://schemas.microsoft.com/office/drawing/2014/main" val="2334880184"/>
                    </a:ext>
                  </a:extLst>
                </a:gridCol>
                <a:gridCol w="966651">
                  <a:extLst>
                    <a:ext uri="{9D8B030D-6E8A-4147-A177-3AD203B41FA5}">
                      <a16:colId xmlns:a16="http://schemas.microsoft.com/office/drawing/2014/main" val="377910219"/>
                    </a:ext>
                  </a:extLst>
                </a:gridCol>
                <a:gridCol w="966651">
                  <a:extLst>
                    <a:ext uri="{9D8B030D-6E8A-4147-A177-3AD203B41FA5}">
                      <a16:colId xmlns:a16="http://schemas.microsoft.com/office/drawing/2014/main" val="1513624534"/>
                    </a:ext>
                  </a:extLst>
                </a:gridCol>
                <a:gridCol w="966651">
                  <a:extLst>
                    <a:ext uri="{9D8B030D-6E8A-4147-A177-3AD203B41FA5}">
                      <a16:colId xmlns:a16="http://schemas.microsoft.com/office/drawing/2014/main" val="579366324"/>
                    </a:ext>
                  </a:extLst>
                </a:gridCol>
              </a:tblGrid>
              <a:tr h="218113"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Patient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Ag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Gender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Group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Treatment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91501525"/>
                  </a:ext>
                </a:extLst>
              </a:tr>
              <a:tr h="218113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4615785"/>
                  </a:ext>
                </a:extLst>
              </a:tr>
              <a:tr h="238502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HC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65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HC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Untreated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40057265"/>
                  </a:ext>
                </a:extLst>
              </a:tr>
              <a:tr h="226686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HC2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52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HC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Untreated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1381508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HC3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32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HC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Untreated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06518034"/>
                  </a:ext>
                </a:extLst>
              </a:tr>
              <a:tr h="271021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HC4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6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HC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Untreated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80092367"/>
                  </a:ext>
                </a:extLst>
              </a:tr>
              <a:tr h="249382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HC5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29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HC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Untreated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47438631"/>
                  </a:ext>
                </a:extLst>
              </a:tr>
              <a:tr h="257694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HC6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55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HC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Untreated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58584256"/>
                  </a:ext>
                </a:extLst>
              </a:tr>
              <a:tr h="257695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HC7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59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HC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Untreated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0423136"/>
                  </a:ext>
                </a:extLst>
              </a:tr>
              <a:tr h="221672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HC8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62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HC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Untreated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62270837"/>
                  </a:ext>
                </a:extLst>
              </a:tr>
              <a:tr h="235527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HC9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53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HC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Untreated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50220081"/>
                  </a:ext>
                </a:extLst>
              </a:tr>
              <a:tr h="224443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HC1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49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HC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Untreated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71262542"/>
                  </a:ext>
                </a:extLst>
              </a:tr>
              <a:tr h="221672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HC1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5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HC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Untreated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8159637"/>
                  </a:ext>
                </a:extLst>
              </a:tr>
              <a:tr h="24384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HC12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63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HC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Untreated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00891407"/>
                  </a:ext>
                </a:extLst>
              </a:tr>
              <a:tr h="249382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HC13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44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HC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Untreated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933151834"/>
                  </a:ext>
                </a:extLst>
              </a:tr>
              <a:tr h="249381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HC14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69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HC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Untreated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45920547"/>
                  </a:ext>
                </a:extLst>
              </a:tr>
              <a:tr h="354434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HC15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55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HC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Untreated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56027941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8C89F431-21B9-4B72-BF44-C5F5C85714DC}"/>
              </a:ext>
            </a:extLst>
          </p:cNvPr>
          <p:cNvSpPr txBox="1"/>
          <p:nvPr/>
        </p:nvSpPr>
        <p:spPr>
          <a:xfrm>
            <a:off x="598515" y="5491700"/>
            <a:ext cx="6633557" cy="2539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50" dirty="0">
                <a:latin typeface="Palatino Linotype" panose="02040502050505030304" pitchFamily="18" charset="0"/>
              </a:rPr>
              <a:t>Supplementary Table S1. Demographics of all healthy controls (HC) including gender, age and treatment. </a:t>
            </a:r>
          </a:p>
        </p:txBody>
      </p:sp>
    </p:spTree>
    <p:extLst>
      <p:ext uri="{BB962C8B-B14F-4D97-AF65-F5344CB8AC3E}">
        <p14:creationId xmlns:p14="http://schemas.microsoft.com/office/powerpoint/2010/main" val="32813495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BB5C1D13-3960-486B-B1C7-8DEC831596D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67628585"/>
              </p:ext>
            </p:extLst>
          </p:nvPr>
        </p:nvGraphicFramePr>
        <p:xfrm>
          <a:off x="931024" y="937096"/>
          <a:ext cx="7140028" cy="3508896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00942">
                  <a:extLst>
                    <a:ext uri="{9D8B030D-6E8A-4147-A177-3AD203B41FA5}">
                      <a16:colId xmlns:a16="http://schemas.microsoft.com/office/drawing/2014/main" val="630714373"/>
                    </a:ext>
                  </a:extLst>
                </a:gridCol>
                <a:gridCol w="669176">
                  <a:extLst>
                    <a:ext uri="{9D8B030D-6E8A-4147-A177-3AD203B41FA5}">
                      <a16:colId xmlns:a16="http://schemas.microsoft.com/office/drawing/2014/main" val="2334880184"/>
                    </a:ext>
                  </a:extLst>
                </a:gridCol>
                <a:gridCol w="723207">
                  <a:extLst>
                    <a:ext uri="{9D8B030D-6E8A-4147-A177-3AD203B41FA5}">
                      <a16:colId xmlns:a16="http://schemas.microsoft.com/office/drawing/2014/main" val="377910219"/>
                    </a:ext>
                  </a:extLst>
                </a:gridCol>
                <a:gridCol w="698269">
                  <a:extLst>
                    <a:ext uri="{9D8B030D-6E8A-4147-A177-3AD203B41FA5}">
                      <a16:colId xmlns:a16="http://schemas.microsoft.com/office/drawing/2014/main" val="1513624534"/>
                    </a:ext>
                  </a:extLst>
                </a:gridCol>
                <a:gridCol w="1255222">
                  <a:extLst>
                    <a:ext uri="{9D8B030D-6E8A-4147-A177-3AD203B41FA5}">
                      <a16:colId xmlns:a16="http://schemas.microsoft.com/office/drawing/2014/main" val="890370257"/>
                    </a:ext>
                  </a:extLst>
                </a:gridCol>
                <a:gridCol w="2493212">
                  <a:extLst>
                    <a:ext uri="{9D8B030D-6E8A-4147-A177-3AD203B41FA5}">
                      <a16:colId xmlns:a16="http://schemas.microsoft.com/office/drawing/2014/main" val="579366324"/>
                    </a:ext>
                  </a:extLst>
                </a:gridCol>
              </a:tblGrid>
              <a:tr h="278544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Patient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Ag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Gender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Group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yo endoscopic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Treatment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91501525"/>
                  </a:ext>
                </a:extLst>
              </a:tr>
              <a:tr h="238502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aUC1</a:t>
                      </a: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77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3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Untreated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40057265"/>
                  </a:ext>
                </a:extLst>
              </a:tr>
              <a:tr h="22668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aUC2</a:t>
                      </a: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34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2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Azathioprine+ </a:t>
                      </a: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Inflectra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1381508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aUC3</a:t>
                      </a: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64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2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Vedolizumab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06518034"/>
                  </a:ext>
                </a:extLst>
              </a:tr>
              <a:tr h="271021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aUC4</a:t>
                      </a: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69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2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Untreated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80092367"/>
                  </a:ext>
                </a:extLst>
              </a:tr>
              <a:tr h="249382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aUC5</a:t>
                      </a: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66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2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Adalimumab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47438631"/>
                  </a:ext>
                </a:extLst>
              </a:tr>
              <a:tr h="257694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aUC6</a:t>
                      </a: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39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3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zathioprine+Golimumab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58584256"/>
                  </a:ext>
                </a:extLst>
              </a:tr>
              <a:tr h="257695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aUC7</a:t>
                      </a: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53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2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Mesalazin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0423136"/>
                  </a:ext>
                </a:extLst>
              </a:tr>
              <a:tr h="23275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aUC8</a:t>
                      </a: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46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3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Mesalazine+Inflectra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65947714"/>
                  </a:ext>
                </a:extLst>
              </a:tr>
              <a:tr h="221672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aUC9</a:t>
                      </a: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42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2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Mesalazine+Corticoids+Azathioprin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62270837"/>
                  </a:ext>
                </a:extLst>
              </a:tr>
              <a:tr h="235527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aUC10</a:t>
                      </a: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41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3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Mesalazin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50220081"/>
                  </a:ext>
                </a:extLst>
              </a:tr>
              <a:tr h="224443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aUC11</a:t>
                      </a: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42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2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Mesalazin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71262542"/>
                  </a:ext>
                </a:extLst>
              </a:tr>
              <a:tr h="221672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aUC12</a:t>
                      </a: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43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2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Corticoids+Mesalazin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8159637"/>
                  </a:ext>
                </a:extLst>
              </a:tr>
              <a:tr h="24384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aUC13</a:t>
                      </a: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50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2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Untreated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00891407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A56193A9-BCDF-49BC-94EF-56E1F819AD7B}"/>
              </a:ext>
            </a:extLst>
          </p:cNvPr>
          <p:cNvSpPr txBox="1"/>
          <p:nvPr/>
        </p:nvSpPr>
        <p:spPr>
          <a:xfrm>
            <a:off x="731520" y="4793456"/>
            <a:ext cx="8005156" cy="4154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50" dirty="0">
                <a:latin typeface="Palatino Linotype" panose="02040502050505030304" pitchFamily="18" charset="0"/>
              </a:rPr>
              <a:t>Supplementary Table S2. Demographics of all the patients with active ulcerative colitis (</a:t>
            </a:r>
            <a:r>
              <a:rPr lang="en-US" sz="1050" dirty="0" err="1">
                <a:latin typeface="Palatino Linotype" panose="02040502050505030304" pitchFamily="18" charset="0"/>
              </a:rPr>
              <a:t>aUC</a:t>
            </a:r>
            <a:r>
              <a:rPr lang="en-US" sz="1050" dirty="0">
                <a:latin typeface="Palatino Linotype" panose="02040502050505030304" pitchFamily="18" charset="0"/>
              </a:rPr>
              <a:t>) including gender, age, Mayo Endoscopic score and treatment.</a:t>
            </a:r>
          </a:p>
        </p:txBody>
      </p:sp>
    </p:spTree>
    <p:extLst>
      <p:ext uri="{BB962C8B-B14F-4D97-AF65-F5344CB8AC3E}">
        <p14:creationId xmlns:p14="http://schemas.microsoft.com/office/powerpoint/2010/main" val="22236937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4">
            <a:extLst>
              <a:ext uri="{FF2B5EF4-FFF2-40B4-BE49-F238E27FC236}">
                <a16:creationId xmlns:a16="http://schemas.microsoft.com/office/drawing/2014/main" id="{9AEDE1DC-1E31-47F0-9995-3B3DFF5D299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1795286"/>
              </p:ext>
            </p:extLst>
          </p:nvPr>
        </p:nvGraphicFramePr>
        <p:xfrm>
          <a:off x="897773" y="479718"/>
          <a:ext cx="7094163" cy="4419072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00942">
                  <a:extLst>
                    <a:ext uri="{9D8B030D-6E8A-4147-A177-3AD203B41FA5}">
                      <a16:colId xmlns:a16="http://schemas.microsoft.com/office/drawing/2014/main" val="630714373"/>
                    </a:ext>
                  </a:extLst>
                </a:gridCol>
                <a:gridCol w="669176">
                  <a:extLst>
                    <a:ext uri="{9D8B030D-6E8A-4147-A177-3AD203B41FA5}">
                      <a16:colId xmlns:a16="http://schemas.microsoft.com/office/drawing/2014/main" val="2334880184"/>
                    </a:ext>
                  </a:extLst>
                </a:gridCol>
                <a:gridCol w="723207">
                  <a:extLst>
                    <a:ext uri="{9D8B030D-6E8A-4147-A177-3AD203B41FA5}">
                      <a16:colId xmlns:a16="http://schemas.microsoft.com/office/drawing/2014/main" val="377910219"/>
                    </a:ext>
                  </a:extLst>
                </a:gridCol>
                <a:gridCol w="556953">
                  <a:extLst>
                    <a:ext uri="{9D8B030D-6E8A-4147-A177-3AD203B41FA5}">
                      <a16:colId xmlns:a16="http://schemas.microsoft.com/office/drawing/2014/main" val="1513624534"/>
                    </a:ext>
                  </a:extLst>
                </a:gridCol>
                <a:gridCol w="1117917">
                  <a:extLst>
                    <a:ext uri="{9D8B030D-6E8A-4147-A177-3AD203B41FA5}">
                      <a16:colId xmlns:a16="http://schemas.microsoft.com/office/drawing/2014/main" val="890370257"/>
                    </a:ext>
                  </a:extLst>
                </a:gridCol>
                <a:gridCol w="2725968">
                  <a:extLst>
                    <a:ext uri="{9D8B030D-6E8A-4147-A177-3AD203B41FA5}">
                      <a16:colId xmlns:a16="http://schemas.microsoft.com/office/drawing/2014/main" val="579366324"/>
                    </a:ext>
                  </a:extLst>
                </a:gridCol>
              </a:tblGrid>
              <a:tr h="162344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Patient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g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Gender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Group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Mayo endoscopi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Treatment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91501525"/>
                  </a:ext>
                </a:extLst>
              </a:tr>
              <a:tr h="238502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qUC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50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Femal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/>
                        <a:t>q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0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Untreate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40057265"/>
                  </a:ext>
                </a:extLst>
              </a:tr>
              <a:tr h="22668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qUC2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71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Mal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/>
                        <a:t>q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0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/>
                        <a:t>Untreate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1381508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qUC3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40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Femal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/>
                        <a:t>q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0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/>
                        <a:t>Untreate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06518034"/>
                  </a:ext>
                </a:extLst>
              </a:tr>
              <a:tr h="271021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qUC4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56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/>
                        <a:t>q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0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Adalimumab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80092367"/>
                  </a:ext>
                </a:extLst>
              </a:tr>
              <a:tr h="249382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qUC5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59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/>
                        <a:t>q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/>
                        <a:t>Untreate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47438631"/>
                  </a:ext>
                </a:extLst>
              </a:tr>
              <a:tr h="257694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qUC6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28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/>
                        <a:t>q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/>
                        <a:t>Untreate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58584256"/>
                  </a:ext>
                </a:extLst>
              </a:tr>
              <a:tr h="257695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qUC7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26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/>
                        <a:t>q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/>
                        <a:t>Untreate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0423136"/>
                  </a:ext>
                </a:extLst>
              </a:tr>
              <a:tr h="23275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qUC8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66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/>
                        <a:t>q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Mesalazin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+</a:t>
                      </a: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zathioprine+Inflectra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65947714"/>
                  </a:ext>
                </a:extLst>
              </a:tr>
              <a:tr h="221672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qUC9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6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/>
                        <a:t>q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Mesalazine</a:t>
                      </a: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 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62270837"/>
                  </a:ext>
                </a:extLst>
              </a:tr>
              <a:tr h="235527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qUC1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66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/>
                        <a:t>q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0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zathioprine+Infliximab+acetylsalicylic</a:t>
                      </a: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cid+besylate+atorvastatin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50220081"/>
                  </a:ext>
                </a:extLst>
              </a:tr>
              <a:tr h="224443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qUC1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48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/>
                        <a:t>q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Mesalazin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71262542"/>
                  </a:ext>
                </a:extLst>
              </a:tr>
              <a:tr h="221672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qUC12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58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/>
                        <a:t>q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0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Mesalazin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+mercaptopurin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8159637"/>
                  </a:ext>
                </a:extLst>
              </a:tr>
              <a:tr h="24384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qUC13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54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/>
                        <a:t>q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0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Mesalazin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00891407"/>
                  </a:ext>
                </a:extLst>
              </a:tr>
              <a:tr h="24384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qUC14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73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/>
                        <a:t>q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0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Mesalazin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60449634"/>
                  </a:ext>
                </a:extLst>
              </a:tr>
              <a:tr h="24384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qUC15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45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/>
                        <a:t>q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0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</a:rPr>
                        <a:t>Mesalazine</a:t>
                      </a: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+omeoprazol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90348981"/>
                  </a:ext>
                </a:extLst>
              </a:tr>
            </a:tbl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FADC3748-A137-4904-B265-EA5AB5F5C417}"/>
              </a:ext>
            </a:extLst>
          </p:cNvPr>
          <p:cNvSpPr txBox="1"/>
          <p:nvPr/>
        </p:nvSpPr>
        <p:spPr>
          <a:xfrm>
            <a:off x="897773" y="4898790"/>
            <a:ext cx="7207136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dirty="0">
                <a:latin typeface="Palatino Linotype" panose="02040502050505030304" pitchFamily="18" charset="0"/>
              </a:rPr>
              <a:t>Supplementary Table S3. Demographics of all the patients with quiescent ulcerative colitis (</a:t>
            </a:r>
            <a:r>
              <a:rPr lang="en-US" sz="1000" dirty="0" err="1">
                <a:latin typeface="Palatino Linotype" panose="02040502050505030304" pitchFamily="18" charset="0"/>
              </a:rPr>
              <a:t>qUC</a:t>
            </a:r>
            <a:r>
              <a:rPr lang="en-US" sz="1000" dirty="0">
                <a:latin typeface="Palatino Linotype" panose="02040502050505030304" pitchFamily="18" charset="0"/>
              </a:rPr>
              <a:t>) including gender, age, Mayo Endoscopic score and treatment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38698158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E4607C75-23B0-4670-8654-4DEBB02BEBF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1002173"/>
              </p:ext>
            </p:extLst>
          </p:nvPr>
        </p:nvGraphicFramePr>
        <p:xfrm>
          <a:off x="897773" y="479718"/>
          <a:ext cx="7140028" cy="3961872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00942">
                  <a:extLst>
                    <a:ext uri="{9D8B030D-6E8A-4147-A177-3AD203B41FA5}">
                      <a16:colId xmlns:a16="http://schemas.microsoft.com/office/drawing/2014/main" val="630714373"/>
                    </a:ext>
                  </a:extLst>
                </a:gridCol>
                <a:gridCol w="669176">
                  <a:extLst>
                    <a:ext uri="{9D8B030D-6E8A-4147-A177-3AD203B41FA5}">
                      <a16:colId xmlns:a16="http://schemas.microsoft.com/office/drawing/2014/main" val="2334880184"/>
                    </a:ext>
                  </a:extLst>
                </a:gridCol>
                <a:gridCol w="723207">
                  <a:extLst>
                    <a:ext uri="{9D8B030D-6E8A-4147-A177-3AD203B41FA5}">
                      <a16:colId xmlns:a16="http://schemas.microsoft.com/office/drawing/2014/main" val="377910219"/>
                    </a:ext>
                  </a:extLst>
                </a:gridCol>
                <a:gridCol w="556953">
                  <a:extLst>
                    <a:ext uri="{9D8B030D-6E8A-4147-A177-3AD203B41FA5}">
                      <a16:colId xmlns:a16="http://schemas.microsoft.com/office/drawing/2014/main" val="1513624534"/>
                    </a:ext>
                  </a:extLst>
                </a:gridCol>
                <a:gridCol w="1163782">
                  <a:extLst>
                    <a:ext uri="{9D8B030D-6E8A-4147-A177-3AD203B41FA5}">
                      <a16:colId xmlns:a16="http://schemas.microsoft.com/office/drawing/2014/main" val="890370257"/>
                    </a:ext>
                  </a:extLst>
                </a:gridCol>
                <a:gridCol w="2725968">
                  <a:extLst>
                    <a:ext uri="{9D8B030D-6E8A-4147-A177-3AD203B41FA5}">
                      <a16:colId xmlns:a16="http://schemas.microsoft.com/office/drawing/2014/main" val="579366324"/>
                    </a:ext>
                  </a:extLst>
                </a:gridCol>
              </a:tblGrid>
              <a:tr h="162344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Patient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g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Gender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Group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SES-CD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Treatment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91501525"/>
                  </a:ext>
                </a:extLst>
              </a:tr>
              <a:tr h="238502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CD1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5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5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Untreated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40057265"/>
                  </a:ext>
                </a:extLst>
              </a:tr>
              <a:tr h="22668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aCD2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24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6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Azathioprin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1381508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aCD3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25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9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Ustekimumab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06518034"/>
                  </a:ext>
                </a:extLst>
              </a:tr>
              <a:tr h="271021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aCD4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58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9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Inflectra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80092367"/>
                  </a:ext>
                </a:extLst>
              </a:tr>
              <a:tr h="249382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aCD5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22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18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Vedolizumab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47438631"/>
                  </a:ext>
                </a:extLst>
              </a:tr>
              <a:tr h="257694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aCD6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32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1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zathioprine+Adalimumab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58584256"/>
                  </a:ext>
                </a:extLst>
              </a:tr>
              <a:tr h="257695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aCD7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25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6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Azathioprin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0423136"/>
                  </a:ext>
                </a:extLst>
              </a:tr>
              <a:tr h="23275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aCD8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5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6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zathioprine+Certolizumab</a:t>
                      </a: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 pegol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65947714"/>
                  </a:ext>
                </a:extLst>
              </a:tr>
              <a:tr h="221672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aCD9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59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8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ethotrexat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62270837"/>
                  </a:ext>
                </a:extLst>
              </a:tr>
              <a:tr h="235527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aCD10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62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5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Steroids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50220081"/>
                  </a:ext>
                </a:extLst>
              </a:tr>
              <a:tr h="224443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aCD11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47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8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dalimumab+Mesalazin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71262542"/>
                  </a:ext>
                </a:extLst>
              </a:tr>
              <a:tr h="221672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aCD12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27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3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Untreated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8159637"/>
                  </a:ext>
                </a:extLst>
              </a:tr>
              <a:tr h="24384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aCD13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54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5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Untreated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00891407"/>
                  </a:ext>
                </a:extLst>
              </a:tr>
              <a:tr h="24384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aCD14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29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4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Mesalazine+Teriflunomid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60449634"/>
                  </a:ext>
                </a:extLst>
              </a:tr>
              <a:tr h="24384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aCD15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2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6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Vedolizumab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90348981"/>
                  </a:ext>
                </a:extLst>
              </a:tr>
            </a:tbl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2E5F40EE-0DAB-4D19-ABC0-4BC94D68419D}"/>
              </a:ext>
            </a:extLst>
          </p:cNvPr>
          <p:cNvSpPr txBox="1"/>
          <p:nvPr/>
        </p:nvSpPr>
        <p:spPr>
          <a:xfrm>
            <a:off x="822958" y="4637626"/>
            <a:ext cx="7074131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dirty="0">
                <a:latin typeface="Palatino Linotype" panose="02040502050505030304" pitchFamily="18" charset="0"/>
              </a:rPr>
              <a:t>Supplementary Table S4. Demographics of all the patients with active Crohn´s disease (</a:t>
            </a:r>
            <a:r>
              <a:rPr lang="en-US" sz="1000" dirty="0" err="1">
                <a:latin typeface="Palatino Linotype" panose="02040502050505030304" pitchFamily="18" charset="0"/>
              </a:rPr>
              <a:t>aCD</a:t>
            </a:r>
            <a:r>
              <a:rPr lang="en-US" sz="1000" dirty="0">
                <a:latin typeface="Palatino Linotype" panose="02040502050505030304" pitchFamily="18" charset="0"/>
              </a:rPr>
              <a:t>) including gender, age, simplified endoscopic activity score for Crohn´s disease (SES-CD) and treatment.</a:t>
            </a:r>
          </a:p>
        </p:txBody>
      </p:sp>
    </p:spTree>
    <p:extLst>
      <p:ext uri="{BB962C8B-B14F-4D97-AF65-F5344CB8AC3E}">
        <p14:creationId xmlns:p14="http://schemas.microsoft.com/office/powerpoint/2010/main" val="327826686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2052CB57-E0CA-44BB-BDE5-EA6C43CD284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18917254"/>
              </p:ext>
            </p:extLst>
          </p:nvPr>
        </p:nvGraphicFramePr>
        <p:xfrm>
          <a:off x="897773" y="479718"/>
          <a:ext cx="7140028" cy="3718032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00942">
                  <a:extLst>
                    <a:ext uri="{9D8B030D-6E8A-4147-A177-3AD203B41FA5}">
                      <a16:colId xmlns:a16="http://schemas.microsoft.com/office/drawing/2014/main" val="630714373"/>
                    </a:ext>
                  </a:extLst>
                </a:gridCol>
                <a:gridCol w="669176">
                  <a:extLst>
                    <a:ext uri="{9D8B030D-6E8A-4147-A177-3AD203B41FA5}">
                      <a16:colId xmlns:a16="http://schemas.microsoft.com/office/drawing/2014/main" val="2334880184"/>
                    </a:ext>
                  </a:extLst>
                </a:gridCol>
                <a:gridCol w="723207">
                  <a:extLst>
                    <a:ext uri="{9D8B030D-6E8A-4147-A177-3AD203B41FA5}">
                      <a16:colId xmlns:a16="http://schemas.microsoft.com/office/drawing/2014/main" val="377910219"/>
                    </a:ext>
                  </a:extLst>
                </a:gridCol>
                <a:gridCol w="556953">
                  <a:extLst>
                    <a:ext uri="{9D8B030D-6E8A-4147-A177-3AD203B41FA5}">
                      <a16:colId xmlns:a16="http://schemas.microsoft.com/office/drawing/2014/main" val="1513624534"/>
                    </a:ext>
                  </a:extLst>
                </a:gridCol>
                <a:gridCol w="1163782">
                  <a:extLst>
                    <a:ext uri="{9D8B030D-6E8A-4147-A177-3AD203B41FA5}">
                      <a16:colId xmlns:a16="http://schemas.microsoft.com/office/drawing/2014/main" val="890370257"/>
                    </a:ext>
                  </a:extLst>
                </a:gridCol>
                <a:gridCol w="2725968">
                  <a:extLst>
                    <a:ext uri="{9D8B030D-6E8A-4147-A177-3AD203B41FA5}">
                      <a16:colId xmlns:a16="http://schemas.microsoft.com/office/drawing/2014/main" val="579366324"/>
                    </a:ext>
                  </a:extLst>
                </a:gridCol>
              </a:tblGrid>
              <a:tr h="162344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Patient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g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Gender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Group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SES-CD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Treatment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91501525"/>
                  </a:ext>
                </a:extLst>
              </a:tr>
              <a:tr h="238502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qCD1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48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q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Untreated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40057265"/>
                  </a:ext>
                </a:extLst>
              </a:tr>
              <a:tr h="22668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qCD2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46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q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Untreated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1381508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qCD3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22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q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Untreated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06518034"/>
                  </a:ext>
                </a:extLst>
              </a:tr>
              <a:tr h="271021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qCD4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46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q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Unteate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80092367"/>
                  </a:ext>
                </a:extLst>
              </a:tr>
              <a:tr h="249382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qCD5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55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q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Untreated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47438631"/>
                  </a:ext>
                </a:extLst>
              </a:tr>
              <a:tr h="257694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qCD6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7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q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Mesalazin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58584256"/>
                  </a:ext>
                </a:extLst>
              </a:tr>
              <a:tr h="257695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qCD7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57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q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Sulfasalazin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0423136"/>
                  </a:ext>
                </a:extLst>
              </a:tr>
              <a:tr h="23275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qCD8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34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q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Infliximab+Azathioprin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65947714"/>
                  </a:ext>
                </a:extLst>
              </a:tr>
              <a:tr h="221672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qCD9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3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q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Mesalazine+Azathioprine+Inflectra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62270837"/>
                  </a:ext>
                </a:extLst>
              </a:tr>
              <a:tr h="235527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qCD10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28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q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Mesalazine+Budesonid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50220081"/>
                  </a:ext>
                </a:extLst>
              </a:tr>
              <a:tr h="224443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qCD11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35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q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Corticoids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71262542"/>
                  </a:ext>
                </a:extLst>
              </a:tr>
              <a:tr h="221672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qCD12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4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q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Ustekimumab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8159637"/>
                  </a:ext>
                </a:extLst>
              </a:tr>
              <a:tr h="24384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qCD13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6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q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Infliximab+simvastatin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00891407"/>
                  </a:ext>
                </a:extLst>
              </a:tr>
              <a:tr h="24384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qCD14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26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q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zathioprine+Infliximab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60449634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6D1BFDC3-5B88-4411-9E56-D5E875276DED}"/>
              </a:ext>
            </a:extLst>
          </p:cNvPr>
          <p:cNvSpPr txBox="1"/>
          <p:nvPr/>
        </p:nvSpPr>
        <p:spPr>
          <a:xfrm>
            <a:off x="822958" y="4637626"/>
            <a:ext cx="7074131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dirty="0">
                <a:latin typeface="Palatino Linotype" panose="02040502050505030304" pitchFamily="18" charset="0"/>
              </a:rPr>
              <a:t>Supplementary Table S5. Demographics of all the patients with quiescent Crohn’s disease (</a:t>
            </a:r>
            <a:r>
              <a:rPr lang="en-US" sz="1000" dirty="0" err="1">
                <a:latin typeface="Palatino Linotype" panose="02040502050505030304" pitchFamily="18" charset="0"/>
              </a:rPr>
              <a:t>qCD</a:t>
            </a:r>
            <a:r>
              <a:rPr lang="en-US" sz="1000" dirty="0">
                <a:latin typeface="Palatino Linotype" panose="02040502050505030304" pitchFamily="18" charset="0"/>
              </a:rPr>
              <a:t>) including gender, age, simplified endoscopic activity score for Crohn´s disease (SES-CD) and treatment.</a:t>
            </a:r>
          </a:p>
        </p:txBody>
      </p:sp>
    </p:spTree>
    <p:extLst>
      <p:ext uri="{BB962C8B-B14F-4D97-AF65-F5344CB8AC3E}">
        <p14:creationId xmlns:p14="http://schemas.microsoft.com/office/powerpoint/2010/main" val="81989854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E37F38DD-C4E2-4D6F-88E1-4D60DA6E691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8366759"/>
              </p:ext>
            </p:extLst>
          </p:nvPr>
        </p:nvGraphicFramePr>
        <p:xfrm>
          <a:off x="983411" y="552091"/>
          <a:ext cx="6938620" cy="5469303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734655">
                  <a:extLst>
                    <a:ext uri="{9D8B030D-6E8A-4147-A177-3AD203B41FA5}">
                      <a16:colId xmlns:a16="http://schemas.microsoft.com/office/drawing/2014/main" val="377811727"/>
                    </a:ext>
                  </a:extLst>
                </a:gridCol>
                <a:gridCol w="1734655">
                  <a:extLst>
                    <a:ext uri="{9D8B030D-6E8A-4147-A177-3AD203B41FA5}">
                      <a16:colId xmlns:a16="http://schemas.microsoft.com/office/drawing/2014/main" val="2599000928"/>
                    </a:ext>
                  </a:extLst>
                </a:gridCol>
                <a:gridCol w="1734655">
                  <a:extLst>
                    <a:ext uri="{9D8B030D-6E8A-4147-A177-3AD203B41FA5}">
                      <a16:colId xmlns:a16="http://schemas.microsoft.com/office/drawing/2014/main" val="2160779242"/>
                    </a:ext>
                  </a:extLst>
                </a:gridCol>
                <a:gridCol w="1734655">
                  <a:extLst>
                    <a:ext uri="{9D8B030D-6E8A-4147-A177-3AD203B41FA5}">
                      <a16:colId xmlns:a16="http://schemas.microsoft.com/office/drawing/2014/main" val="1945603584"/>
                    </a:ext>
                  </a:extLst>
                </a:gridCol>
              </a:tblGrid>
              <a:tr h="371767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Antibody specificity</a:t>
                      </a:r>
                      <a:endParaRPr lang="en-US" sz="12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</a:rPr>
                        <a:t>Fluorochrome</a:t>
                      </a:r>
                      <a:endParaRPr lang="en-US" sz="120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</a:rPr>
                        <a:t>Clone</a:t>
                      </a:r>
                      <a:endParaRPr lang="en-US" sz="120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Manufacturer</a:t>
                      </a:r>
                      <a:endParaRPr lang="en-US" sz="12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21741298"/>
                  </a:ext>
                </a:extLst>
              </a:tr>
              <a:tr h="318596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CD19</a:t>
                      </a:r>
                      <a:endParaRPr lang="en-US" sz="12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PE-Cy5</a:t>
                      </a:r>
                      <a:endParaRPr lang="en-US" sz="12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MOPC-21</a:t>
                      </a:r>
                      <a:endParaRPr lang="en-US" sz="12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Palatino Linotype" panose="02040502050505030304" pitchFamily="18" charset="0"/>
                        </a:rPr>
                        <a:t>Becton Dickinson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07801880"/>
                  </a:ext>
                </a:extLst>
              </a:tr>
              <a:tr h="318596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CD19</a:t>
                      </a:r>
                      <a:endParaRPr lang="en-US" sz="12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PECF594</a:t>
                      </a:r>
                      <a:endParaRPr lang="en-US" sz="12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Palatino Linotype" panose="02040502050505030304" pitchFamily="18" charset="0"/>
                        </a:rPr>
                        <a:t>HIBI9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 err="1">
                          <a:latin typeface="Palatino Linotype" panose="02040502050505030304" pitchFamily="18" charset="0"/>
                        </a:rPr>
                        <a:t>Biolegend</a:t>
                      </a:r>
                      <a:endParaRPr lang="en-US" sz="1200" b="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05128279"/>
                  </a:ext>
                </a:extLst>
              </a:tr>
              <a:tr h="318596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HLA-DR</a:t>
                      </a:r>
                      <a:endParaRPr lang="en-US" sz="12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BV510</a:t>
                      </a:r>
                      <a:endParaRPr lang="en-US" sz="12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L243</a:t>
                      </a:r>
                      <a:endParaRPr lang="en-US" sz="12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err="1">
                          <a:latin typeface="Palatino Linotype" panose="02040502050505030304" pitchFamily="18" charset="0"/>
                        </a:rPr>
                        <a:t>Biolegend</a:t>
                      </a:r>
                      <a:endParaRPr lang="en-US" sz="12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59807439"/>
                  </a:ext>
                </a:extLst>
              </a:tr>
              <a:tr h="318596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CD14</a:t>
                      </a:r>
                      <a:endParaRPr lang="en-US" sz="12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PECF594</a:t>
                      </a:r>
                      <a:endParaRPr lang="en-US" sz="12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M</a:t>
                      </a:r>
                      <a:r>
                        <a:rPr lang="el-GR" sz="1200" dirty="0"/>
                        <a:t>ϕ</a:t>
                      </a:r>
                      <a:r>
                        <a:rPr lang="en-US" sz="1200" dirty="0"/>
                        <a:t>Pg</a:t>
                      </a:r>
                      <a:endParaRPr lang="en-US" sz="12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Palatino Linotype" panose="02040502050505030304" pitchFamily="18" charset="0"/>
                        </a:rPr>
                        <a:t>Becton Dickinson</a:t>
                      </a: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21009665"/>
                  </a:ext>
                </a:extLst>
              </a:tr>
              <a:tr h="318596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CD14</a:t>
                      </a:r>
                      <a:endParaRPr lang="en-US" sz="12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PE-Cy5</a:t>
                      </a:r>
                      <a:endParaRPr lang="en-US" sz="12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Palatino Linotype" panose="02040502050505030304" pitchFamily="18" charset="0"/>
                        </a:rPr>
                        <a:t>TÜK4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err="1">
                          <a:latin typeface="Palatino Linotype" panose="02040502050505030304" pitchFamily="18" charset="0"/>
                        </a:rPr>
                        <a:t>Miltenyi</a:t>
                      </a:r>
                      <a:r>
                        <a:rPr lang="en-US" sz="1200" dirty="0"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dirty="0" err="1">
                          <a:latin typeface="Palatino Linotype" panose="02040502050505030304" pitchFamily="18" charset="0"/>
                        </a:rPr>
                        <a:t>Biotec</a:t>
                      </a:r>
                      <a:endParaRPr lang="en-US" sz="12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50408677"/>
                  </a:ext>
                </a:extLst>
              </a:tr>
              <a:tr h="318596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CD123</a:t>
                      </a:r>
                      <a:endParaRPr lang="en-US" sz="12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FITC</a:t>
                      </a:r>
                      <a:endParaRPr lang="en-US" sz="12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7G3</a:t>
                      </a:r>
                      <a:endParaRPr lang="en-US" sz="12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Palatino Linotype" panose="02040502050505030304" pitchFamily="18" charset="0"/>
                        </a:rPr>
                        <a:t>Becton Dickinson</a:t>
                      </a: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98176469"/>
                  </a:ext>
                </a:extLst>
              </a:tr>
              <a:tr h="318596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CD123</a:t>
                      </a:r>
                      <a:endParaRPr lang="en-US" sz="12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Palatino Linotype" panose="02040502050505030304" pitchFamily="18" charset="0"/>
                        </a:rPr>
                        <a:t>APC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Palatino Linotype" panose="02040502050505030304" pitchFamily="18" charset="0"/>
                        </a:rPr>
                        <a:t>6H6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err="1">
                          <a:latin typeface="Palatino Linotype" panose="02040502050505030304" pitchFamily="18" charset="0"/>
                        </a:rPr>
                        <a:t>Biolegend</a:t>
                      </a:r>
                      <a:endParaRPr lang="en-US" sz="12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40097247"/>
                  </a:ext>
                </a:extLst>
              </a:tr>
              <a:tr h="318596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CD11c</a:t>
                      </a:r>
                      <a:endParaRPr lang="en-US" sz="12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Alexa Fluor 700</a:t>
                      </a:r>
                      <a:endParaRPr lang="en-US" sz="12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Bu15</a:t>
                      </a:r>
                      <a:endParaRPr lang="en-US" sz="12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err="1">
                          <a:latin typeface="Palatino Linotype" panose="02040502050505030304" pitchFamily="18" charset="0"/>
                        </a:rPr>
                        <a:t>Biolegend</a:t>
                      </a:r>
                      <a:endParaRPr lang="en-US" sz="12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12398269"/>
                  </a:ext>
                </a:extLst>
              </a:tr>
              <a:tr h="318596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CD11c</a:t>
                      </a:r>
                      <a:endParaRPr lang="en-US" sz="12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Palatino Linotype" panose="02040502050505030304" pitchFamily="18" charset="0"/>
                        </a:rPr>
                        <a:t>FITC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Palatino Linotype" panose="02040502050505030304" pitchFamily="18" charset="0"/>
                        </a:rPr>
                        <a:t>MJ4-27G12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err="1">
                          <a:latin typeface="Palatino Linotype" panose="02040502050505030304" pitchFamily="18" charset="0"/>
                        </a:rPr>
                        <a:t>Miltenyi</a:t>
                      </a:r>
                      <a:r>
                        <a:rPr lang="en-US" sz="1200" dirty="0"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dirty="0" err="1">
                          <a:latin typeface="Palatino Linotype" panose="02040502050505030304" pitchFamily="18" charset="0"/>
                        </a:rPr>
                        <a:t>Biotec</a:t>
                      </a:r>
                      <a:endParaRPr lang="en-US" sz="12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13379557"/>
                  </a:ext>
                </a:extLst>
              </a:tr>
              <a:tr h="318596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CD141</a:t>
                      </a:r>
                      <a:endParaRPr lang="en-US" sz="12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BV421</a:t>
                      </a:r>
                      <a:endParaRPr lang="en-US" sz="12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AD5-14H12</a:t>
                      </a:r>
                      <a:endParaRPr lang="en-US" sz="12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err="1">
                          <a:latin typeface="Palatino Linotype" panose="02040502050505030304" pitchFamily="18" charset="0"/>
                        </a:rPr>
                        <a:t>Miltenyi</a:t>
                      </a:r>
                      <a:r>
                        <a:rPr lang="en-US" sz="1200" dirty="0"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dirty="0" err="1">
                          <a:latin typeface="Palatino Linotype" panose="02040502050505030304" pitchFamily="18" charset="0"/>
                        </a:rPr>
                        <a:t>Biotec</a:t>
                      </a:r>
                      <a:endParaRPr lang="en-US" sz="12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40478603"/>
                  </a:ext>
                </a:extLst>
              </a:tr>
              <a:tr h="318596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CD1c</a:t>
                      </a:r>
                      <a:endParaRPr lang="en-US" sz="12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PE-Cy7</a:t>
                      </a:r>
                      <a:endParaRPr lang="en-US" sz="12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L161</a:t>
                      </a:r>
                      <a:endParaRPr lang="en-US" sz="12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err="1">
                          <a:latin typeface="Palatino Linotype" panose="02040502050505030304" pitchFamily="18" charset="0"/>
                        </a:rPr>
                        <a:t>Biolegend</a:t>
                      </a:r>
                      <a:endParaRPr lang="en-US" sz="12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2659247"/>
                  </a:ext>
                </a:extLst>
              </a:tr>
              <a:tr h="318596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Integrin </a:t>
                      </a:r>
                      <a:r>
                        <a:rPr lang="el-GR" sz="1200" dirty="0"/>
                        <a:t>β</a:t>
                      </a:r>
                      <a:r>
                        <a:rPr lang="en-US" sz="1200" dirty="0"/>
                        <a:t>7</a:t>
                      </a:r>
                      <a:endParaRPr lang="en-US" sz="12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PE</a:t>
                      </a:r>
                      <a:endParaRPr lang="en-US" sz="12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FIB504</a:t>
                      </a:r>
                      <a:endParaRPr lang="en-US" sz="12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Palatino Linotype" panose="02040502050505030304" pitchFamily="18" charset="0"/>
                        </a:rPr>
                        <a:t>Becton Dickinson</a:t>
                      </a: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14878639"/>
                  </a:ext>
                </a:extLst>
              </a:tr>
              <a:tr h="318596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CCR2</a:t>
                      </a:r>
                      <a:endParaRPr lang="en-US" sz="12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BV605</a:t>
                      </a:r>
                      <a:endParaRPr lang="en-US" sz="12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K036C2</a:t>
                      </a:r>
                      <a:endParaRPr lang="en-US" sz="12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err="1">
                          <a:latin typeface="Palatino Linotype" panose="02040502050505030304" pitchFamily="18" charset="0"/>
                        </a:rPr>
                        <a:t>Biolegend</a:t>
                      </a:r>
                      <a:endParaRPr lang="en-US" sz="12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78223055"/>
                  </a:ext>
                </a:extLst>
              </a:tr>
              <a:tr h="318596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CCR5</a:t>
                      </a:r>
                      <a:endParaRPr lang="en-US" sz="12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BV711</a:t>
                      </a:r>
                      <a:endParaRPr lang="en-US" sz="12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2D7/CCR5</a:t>
                      </a:r>
                      <a:endParaRPr lang="en-US" sz="12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Palatino Linotype" panose="02040502050505030304" pitchFamily="18" charset="0"/>
                        </a:rPr>
                        <a:t>Becton Dickinson</a:t>
                      </a: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088903"/>
                  </a:ext>
                </a:extLst>
              </a:tr>
              <a:tr h="318596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CCR6</a:t>
                      </a:r>
                      <a:endParaRPr lang="en-US" sz="12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BV785</a:t>
                      </a:r>
                      <a:endParaRPr lang="en-US" sz="12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G034E3</a:t>
                      </a:r>
                      <a:endParaRPr lang="en-US" sz="12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err="1">
                          <a:latin typeface="Palatino Linotype" panose="02040502050505030304" pitchFamily="18" charset="0"/>
                        </a:rPr>
                        <a:t>Biolegend</a:t>
                      </a:r>
                      <a:endParaRPr lang="en-US" sz="12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01081245"/>
                  </a:ext>
                </a:extLst>
              </a:tr>
              <a:tr h="318596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CCR9</a:t>
                      </a:r>
                      <a:endParaRPr lang="en-US" sz="12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APC</a:t>
                      </a:r>
                      <a:endParaRPr lang="en-US" sz="12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567976</a:t>
                      </a:r>
                      <a:endParaRPr lang="en-US" sz="12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Palatino Linotype" panose="02040502050505030304" pitchFamily="18" charset="0"/>
                        </a:rPr>
                        <a:t>Becton Dickinson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61765610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992B040F-09FC-4FA6-A2B7-1F36DC821C34}"/>
              </a:ext>
            </a:extLst>
          </p:cNvPr>
          <p:cNvSpPr txBox="1"/>
          <p:nvPr/>
        </p:nvSpPr>
        <p:spPr>
          <a:xfrm>
            <a:off x="897146" y="6097847"/>
            <a:ext cx="76560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Palatino Linotype" panose="02040502050505030304" pitchFamily="18" charset="0"/>
              </a:rPr>
              <a:t>Supplementary Table S6. </a:t>
            </a:r>
            <a:r>
              <a:rPr lang="en-US" sz="1000" b="0" i="0" u="none" strike="noStrike" baseline="0" dirty="0">
                <a:latin typeface="Palatino Linotype" panose="02040502050505030304" pitchFamily="18" charset="0"/>
              </a:rPr>
              <a:t>Specificity, clone, fluorochrome and manufacturer of the different monoclonal antibodies used in this work.</a:t>
            </a:r>
            <a:endParaRPr lang="en-US" sz="10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5950818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6E1E2AB-B537-4308-914A-FEAC71615070}"/>
              </a:ext>
            </a:extLst>
          </p:cNvPr>
          <p:cNvSpPr txBox="1"/>
          <p:nvPr/>
        </p:nvSpPr>
        <p:spPr>
          <a:xfrm>
            <a:off x="118315" y="5506633"/>
            <a:ext cx="8999269" cy="86177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just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Supplementary </a:t>
            </a:r>
            <a:r>
              <a:rPr lang="en-US" sz="1000" dirty="0">
                <a:solidFill>
                  <a:prstClr val="black"/>
                </a:solidFill>
                <a:latin typeface="Palatino Linotype" panose="02040502050505030304" pitchFamily="18" charset="0"/>
              </a:rPr>
              <a:t>Figure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S</a:t>
            </a:r>
            <a:r>
              <a:rPr lang="en-US" sz="1000" dirty="0">
                <a:solidFill>
                  <a:prstClr val="black"/>
                </a:solidFill>
                <a:latin typeface="Palatino Linotype" panose="02040502050505030304" pitchFamily="18" charset="0"/>
              </a:rPr>
              <a:t>1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. Surface expression of beta7, CCR2, CCR5, CCR6 and CCR9 on human circulating DC subsets (</a:t>
            </a:r>
            <a:r>
              <a:rPr kumimoji="0" lang="en-US" sz="10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pDC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, CD1c and CD141) in HC and patients with active ulcerative colitis (</a:t>
            </a:r>
            <a:r>
              <a:rPr kumimoji="0" lang="en-US" sz="10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aUC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), quiescent ulcerative colitis (</a:t>
            </a:r>
            <a:r>
              <a:rPr kumimoji="0" lang="en-US" sz="10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qUC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), active Crohn’s disease (</a:t>
            </a:r>
            <a:r>
              <a:rPr kumimoji="0" lang="en-US" sz="10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aCD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) and quiescent Crohn’s disease (</a:t>
            </a:r>
            <a:r>
              <a:rPr kumimoji="0" lang="en-US" sz="10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qCD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). All determinations were performed after 18h culture in the presence of  infliximab (white circle), </a:t>
            </a:r>
            <a:r>
              <a:rPr kumimoji="0" lang="en-US" sz="10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infletra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(grey square) or adalimumab (back triangle) and the percentages of positive cells (%) were determined within each different subset . One-way ANOVA with subsequent ad-hoc comparison was performed to compare beta7, CCR2, CCR5, CCR6 and CCR9 expression levels on </a:t>
            </a:r>
            <a:r>
              <a:rPr kumimoji="0" lang="en-US" sz="10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pDC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, CD1c and CD141 comparing each drug</a:t>
            </a:r>
            <a:r>
              <a:rPr lang="en-US" sz="1000" dirty="0">
                <a:solidFill>
                  <a:prstClr val="black"/>
                </a:solidFill>
                <a:latin typeface="Palatino Linotype" panose="02040502050505030304" pitchFamily="18" charset="0"/>
              </a:rPr>
              <a:t> with the others. </a:t>
            </a:r>
            <a:endParaRPr kumimoji="0" 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Palatino Linotype" panose="02040502050505030304" pitchFamily="18" charset="0"/>
              <a:ea typeface="+mn-ea"/>
              <a:cs typeface="+mn-cs"/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7A383483-2FC5-4AFB-8593-1241D49A45C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4382" r="28095"/>
          <a:stretch/>
        </p:blipFill>
        <p:spPr>
          <a:xfrm>
            <a:off x="83123" y="774141"/>
            <a:ext cx="1828800" cy="1227598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D7E20085-0949-4F55-BC47-8B4ECE4FE17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72890" t="18113" b="54749"/>
          <a:stretch/>
        </p:blipFill>
        <p:spPr>
          <a:xfrm>
            <a:off x="7656021" y="540964"/>
            <a:ext cx="889463" cy="501949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8D4850BF-21CC-4E51-80D0-C3F5AF67497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4811" r="28659"/>
          <a:stretch/>
        </p:blipFill>
        <p:spPr>
          <a:xfrm>
            <a:off x="1884538" y="773084"/>
            <a:ext cx="1828800" cy="1228655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E72E7545-93CC-4681-B8FA-66C360CAE638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14073" r="28486"/>
          <a:stretch/>
        </p:blipFill>
        <p:spPr>
          <a:xfrm>
            <a:off x="3684476" y="765454"/>
            <a:ext cx="1828800" cy="1236285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720B4D76-081A-4D61-BB52-07E10E84142E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14690" r="27445"/>
          <a:stretch/>
        </p:blipFill>
        <p:spPr>
          <a:xfrm>
            <a:off x="5487369" y="791939"/>
            <a:ext cx="1828800" cy="120980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79AB1D68-8747-4804-A3C3-53EBD119F6D2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13765" r="28516"/>
          <a:stretch/>
        </p:blipFill>
        <p:spPr>
          <a:xfrm>
            <a:off x="7288785" y="760483"/>
            <a:ext cx="1828800" cy="1241256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AA388356-D81E-42F8-85CD-B1F4F5904E95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15307" r="27627"/>
          <a:stretch/>
        </p:blipFill>
        <p:spPr>
          <a:xfrm>
            <a:off x="83123" y="2277079"/>
            <a:ext cx="1828800" cy="1185229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539499DC-3616-40D6-B5EC-57FEB517F527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t="15307" r="28486"/>
          <a:stretch/>
        </p:blipFill>
        <p:spPr>
          <a:xfrm>
            <a:off x="1884538" y="2243771"/>
            <a:ext cx="1828800" cy="1218537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94B1B227-67C3-4843-9A29-7B288B688AC9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t="15155" r="28659"/>
          <a:stretch/>
        </p:blipFill>
        <p:spPr>
          <a:xfrm>
            <a:off x="3684476" y="2238614"/>
            <a:ext cx="1828800" cy="1223694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57B86D13-4F60-449F-A629-EB22E2283535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t="13885" r="28480"/>
          <a:stretch/>
        </p:blipFill>
        <p:spPr>
          <a:xfrm>
            <a:off x="5487369" y="2242801"/>
            <a:ext cx="1828800" cy="1219507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FE579E5E-474A-4D8F-A70F-DDB419B288E8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t="14802" r="28251"/>
          <a:stretch/>
        </p:blipFill>
        <p:spPr>
          <a:xfrm>
            <a:off x="7288785" y="2240520"/>
            <a:ext cx="1828800" cy="1221788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FC98932B-6672-437A-9AF8-04DDD13BB1E2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t="15676" r="28833"/>
          <a:stretch/>
        </p:blipFill>
        <p:spPr>
          <a:xfrm>
            <a:off x="83123" y="3805931"/>
            <a:ext cx="1828800" cy="1219153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960A8A4B-2815-450D-AAF6-859307B7DAAA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t="14493" r="27271"/>
          <a:stretch/>
        </p:blipFill>
        <p:spPr>
          <a:xfrm>
            <a:off x="1884538" y="3815387"/>
            <a:ext cx="1828800" cy="1209697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4F68ECDA-3B02-4016-BAA3-02F6919351FE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t="14444" r="28690"/>
          <a:stretch/>
        </p:blipFill>
        <p:spPr>
          <a:xfrm>
            <a:off x="3684476" y="3790604"/>
            <a:ext cx="1828800" cy="1234480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2CAD5149-0848-49B6-970D-75E0AB6B14EE}"/>
              </a:ext>
            </a:extLst>
          </p:cNvPr>
          <p:cNvPicPr>
            <a:picLocks noChangeAspect="1"/>
          </p:cNvPicPr>
          <p:nvPr/>
        </p:nvPicPr>
        <p:blipFill rotWithShape="1">
          <a:blip r:embed="rId15"/>
          <a:srcRect t="14578" r="27114"/>
          <a:stretch/>
        </p:blipFill>
        <p:spPr>
          <a:xfrm>
            <a:off x="5487369" y="3838084"/>
            <a:ext cx="1828800" cy="1187000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9F149F95-F378-426D-8A59-159BF1A99C25}"/>
              </a:ext>
            </a:extLst>
          </p:cNvPr>
          <p:cNvPicPr>
            <a:picLocks noChangeAspect="1"/>
          </p:cNvPicPr>
          <p:nvPr/>
        </p:nvPicPr>
        <p:blipFill rotWithShape="1">
          <a:blip r:embed="rId16"/>
          <a:srcRect t="15993" r="28618"/>
          <a:stretch/>
        </p:blipFill>
        <p:spPr>
          <a:xfrm>
            <a:off x="7288785" y="3814175"/>
            <a:ext cx="1828800" cy="12109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9984818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A2FE7820-BDFE-5F56-462C-7E88A03B9D9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2862"/>
          <a:stretch/>
        </p:blipFill>
        <p:spPr>
          <a:xfrm>
            <a:off x="764972" y="2013820"/>
            <a:ext cx="1371600" cy="1726955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6D592EA1-40DD-D9C8-02C9-2D4A4FFEDB3E}"/>
              </a:ext>
            </a:extLst>
          </p:cNvPr>
          <p:cNvSpPr txBox="1"/>
          <p:nvPr/>
        </p:nvSpPr>
        <p:spPr>
          <a:xfrm>
            <a:off x="928775" y="-9942"/>
            <a:ext cx="1371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HC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FFEA713-917F-19FD-4702-98CB7389BD79}"/>
              </a:ext>
            </a:extLst>
          </p:cNvPr>
          <p:cNvSpPr txBox="1"/>
          <p:nvPr/>
        </p:nvSpPr>
        <p:spPr>
          <a:xfrm>
            <a:off x="2378019" y="-9942"/>
            <a:ext cx="1371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err="1"/>
              <a:t>aUC</a:t>
            </a:r>
            <a:endParaRPr lang="en-US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24B3E03-275C-43D0-DD8A-B8D7F142BDDF}"/>
              </a:ext>
            </a:extLst>
          </p:cNvPr>
          <p:cNvSpPr txBox="1"/>
          <p:nvPr/>
        </p:nvSpPr>
        <p:spPr>
          <a:xfrm>
            <a:off x="3886200" y="-9942"/>
            <a:ext cx="1371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err="1"/>
              <a:t>qUC</a:t>
            </a:r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E9E9B88-C974-F9A2-6C6D-0E8C4FABD3A3}"/>
              </a:ext>
            </a:extLst>
          </p:cNvPr>
          <p:cNvSpPr txBox="1"/>
          <p:nvPr/>
        </p:nvSpPr>
        <p:spPr>
          <a:xfrm>
            <a:off x="5437109" y="-9942"/>
            <a:ext cx="1371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err="1"/>
              <a:t>aCD</a:t>
            </a:r>
            <a:endParaRPr lang="en-US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A8C2C70-FC47-880D-9A03-3CDA13F5C9DD}"/>
              </a:ext>
            </a:extLst>
          </p:cNvPr>
          <p:cNvSpPr txBox="1"/>
          <p:nvPr/>
        </p:nvSpPr>
        <p:spPr>
          <a:xfrm>
            <a:off x="7032154" y="76495"/>
            <a:ext cx="1371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err="1"/>
              <a:t>qCD</a:t>
            </a:r>
            <a:endParaRPr lang="en-US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C27C08A-454E-1E2F-DDBD-D7F32849468E}"/>
              </a:ext>
            </a:extLst>
          </p:cNvPr>
          <p:cNvSpPr txBox="1"/>
          <p:nvPr/>
        </p:nvSpPr>
        <p:spPr>
          <a:xfrm>
            <a:off x="-89142" y="907670"/>
            <a:ext cx="10179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err="1"/>
              <a:t>pDC</a:t>
            </a:r>
            <a:endParaRPr lang="en-US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0503389-4B1E-0026-1291-EAF45B630675}"/>
              </a:ext>
            </a:extLst>
          </p:cNvPr>
          <p:cNvSpPr txBox="1"/>
          <p:nvPr/>
        </p:nvSpPr>
        <p:spPr>
          <a:xfrm>
            <a:off x="-89142" y="2429587"/>
            <a:ext cx="10179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DC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753D2D4-8AEE-3969-CF7A-E55F1824F72D}"/>
              </a:ext>
            </a:extLst>
          </p:cNvPr>
          <p:cNvSpPr txBox="1"/>
          <p:nvPr/>
        </p:nvSpPr>
        <p:spPr>
          <a:xfrm>
            <a:off x="-89142" y="4487778"/>
            <a:ext cx="10179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DC2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B04FF8D2-87F3-0D84-560C-9BA67655815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1434"/>
          <a:stretch/>
        </p:blipFill>
        <p:spPr>
          <a:xfrm>
            <a:off x="2322351" y="410789"/>
            <a:ext cx="1371600" cy="1739927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1F82B952-A1EB-576D-F89C-9A0338728695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11434"/>
          <a:stretch/>
        </p:blipFill>
        <p:spPr>
          <a:xfrm>
            <a:off x="2322351" y="1993216"/>
            <a:ext cx="1371600" cy="1747559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31D4339E-B51E-33FA-CBDF-6E19DE6F04EF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11434"/>
          <a:stretch/>
        </p:blipFill>
        <p:spPr>
          <a:xfrm>
            <a:off x="3879730" y="1997031"/>
            <a:ext cx="1371600" cy="1739927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55DD7E7E-E19E-6A51-C5B2-C2BC5DBB577A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10775"/>
          <a:stretch/>
        </p:blipFill>
        <p:spPr>
          <a:xfrm>
            <a:off x="3879730" y="4125761"/>
            <a:ext cx="1371600" cy="1625143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946FBA83-30DD-D4D3-C192-2A67A2274104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13130"/>
          <a:stretch/>
        </p:blipFill>
        <p:spPr>
          <a:xfrm>
            <a:off x="5437109" y="375100"/>
            <a:ext cx="1371600" cy="1706611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7E27A155-B442-D8BD-D3D3-376054BAC8F3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t="11928"/>
          <a:stretch/>
        </p:blipFill>
        <p:spPr>
          <a:xfrm>
            <a:off x="5437109" y="2006729"/>
            <a:ext cx="1371600" cy="1730229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2F1B1FD8-3595-0DD8-E13A-932399E5EA3F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t="12658"/>
          <a:stretch/>
        </p:blipFill>
        <p:spPr>
          <a:xfrm>
            <a:off x="5437109" y="4130694"/>
            <a:ext cx="1371600" cy="1664993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0C753740-E3F8-0821-CF36-9709404672BE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t="12862"/>
          <a:stretch/>
        </p:blipFill>
        <p:spPr>
          <a:xfrm>
            <a:off x="7032154" y="376190"/>
            <a:ext cx="1371600" cy="1704430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0A79FBCE-3145-24A1-AEA7-430B65E0D893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t="11595"/>
          <a:stretch/>
        </p:blipFill>
        <p:spPr>
          <a:xfrm>
            <a:off x="7032154" y="1930533"/>
            <a:ext cx="1371600" cy="1736771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BDFD1869-05E8-51F7-11FD-BAA05A89107E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t="13573"/>
          <a:stretch/>
        </p:blipFill>
        <p:spPr>
          <a:xfrm>
            <a:off x="7032154" y="4125761"/>
            <a:ext cx="1371600" cy="1633715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E0FFA790-3D1D-F683-3262-A02069E22A82}"/>
              </a:ext>
            </a:extLst>
          </p:cNvPr>
          <p:cNvSpPr txBox="1"/>
          <p:nvPr/>
        </p:nvSpPr>
        <p:spPr>
          <a:xfrm>
            <a:off x="50109" y="5873158"/>
            <a:ext cx="9052560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Supplementary </a:t>
            </a:r>
            <a:r>
              <a:rPr lang="en-US" sz="1050" dirty="0">
                <a:solidFill>
                  <a:prstClr val="black"/>
                </a:solidFill>
                <a:latin typeface="Palatino Linotype" panose="02040502050505030304" pitchFamily="18" charset="0"/>
              </a:rPr>
              <a:t>Figure</a:t>
            </a: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S2. </a:t>
            </a:r>
            <a:r>
              <a:rPr lang="en-GB" sz="105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Peripheral blood mononuclear cells from healthy controls (HC) and patients with active ulcerative colitis (</a:t>
            </a:r>
            <a:r>
              <a:rPr lang="en-GB" sz="1050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aUC</a:t>
            </a:r>
            <a:r>
              <a:rPr lang="en-GB" sz="105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), quiescent ulcerative colitis (</a:t>
            </a:r>
            <a:r>
              <a:rPr lang="en-GB" sz="1050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qUC</a:t>
            </a:r>
            <a:r>
              <a:rPr lang="en-GB" sz="105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), active Crohn’s disease (</a:t>
            </a:r>
            <a:r>
              <a:rPr lang="en-GB" sz="1050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aCD</a:t>
            </a:r>
            <a:r>
              <a:rPr lang="en-GB" sz="105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) and quiescent Crohn’s disease (</a:t>
            </a:r>
            <a:r>
              <a:rPr lang="en-GB" sz="1050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qCD</a:t>
            </a:r>
            <a:r>
              <a:rPr lang="en-GB" sz="105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) were allowed to migrated towards gut-homing </a:t>
            </a:r>
            <a:r>
              <a:rPr lang="en-GB" sz="1050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chemoattractants</a:t>
            </a:r>
            <a:r>
              <a:rPr lang="en-GB" sz="105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including CCL2, CCL25 and MadCam1. Graphs represent the number of migrated DC subsets (</a:t>
            </a:r>
            <a:r>
              <a:rPr lang="en-GB" sz="1050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pDC</a:t>
            </a:r>
            <a:r>
              <a:rPr lang="en-GB" sz="105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, cDC2 and cDC1), identified as in Figure 1. (mean± SEM n=15). One-way ANOVA with Turkey correction was applied to compare with the basal condition, displayed as * . </a:t>
            </a:r>
            <a:r>
              <a:rPr lang="en-US" sz="105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p-values &lt; 0.05 were considered significant (* &lt; 0.05, ** &lt; 0.01, *** &lt; 0.001).</a:t>
            </a:r>
          </a:p>
          <a:p>
            <a:pPr algn="just"/>
            <a:endParaRPr lang="en-US" sz="1050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6FB2B93-6207-7D8F-F51B-134200BCA058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t="12586"/>
          <a:stretch/>
        </p:blipFill>
        <p:spPr>
          <a:xfrm>
            <a:off x="764972" y="410789"/>
            <a:ext cx="1371600" cy="1732427"/>
          </a:xfrm>
          <a:prstGeom prst="rect">
            <a:avLst/>
          </a:prstGeom>
        </p:spPr>
      </p:pic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4E3DE3A7-1AE3-0B7E-4DC7-9DB7F1E46D38}"/>
              </a:ext>
            </a:extLst>
          </p:cNvPr>
          <p:cNvCxnSpPr>
            <a:cxnSpLocks/>
          </p:cNvCxnSpPr>
          <p:nvPr/>
        </p:nvCxnSpPr>
        <p:spPr>
          <a:xfrm>
            <a:off x="1274015" y="677838"/>
            <a:ext cx="23201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EC0F6928-298B-2E39-C42D-1C92B5BD4544}"/>
              </a:ext>
            </a:extLst>
          </p:cNvPr>
          <p:cNvSpPr txBox="1"/>
          <p:nvPr/>
        </p:nvSpPr>
        <p:spPr>
          <a:xfrm>
            <a:off x="1274014" y="470845"/>
            <a:ext cx="228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*</a:t>
            </a: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54A10580-A2C8-0E95-9F35-35E6730C26F9}"/>
              </a:ext>
            </a:extLst>
          </p:cNvPr>
          <p:cNvCxnSpPr>
            <a:cxnSpLocks/>
          </p:cNvCxnSpPr>
          <p:nvPr/>
        </p:nvCxnSpPr>
        <p:spPr>
          <a:xfrm>
            <a:off x="1524591" y="677838"/>
            <a:ext cx="23201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73E9355F-8DE2-1963-0B96-81979CF70FC3}"/>
              </a:ext>
            </a:extLst>
          </p:cNvPr>
          <p:cNvSpPr txBox="1"/>
          <p:nvPr/>
        </p:nvSpPr>
        <p:spPr>
          <a:xfrm>
            <a:off x="1524590" y="470845"/>
            <a:ext cx="228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*</a:t>
            </a:r>
          </a:p>
        </p:txBody>
      </p: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A8F3A5A0-4714-AB3F-A000-E63733C90FC4}"/>
              </a:ext>
            </a:extLst>
          </p:cNvPr>
          <p:cNvCxnSpPr/>
          <p:nvPr/>
        </p:nvCxnSpPr>
        <p:spPr>
          <a:xfrm>
            <a:off x="1511489" y="489137"/>
            <a:ext cx="45378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86BBA949-0E86-A8CE-84D0-64DE7C34D951}"/>
              </a:ext>
            </a:extLst>
          </p:cNvPr>
          <p:cNvSpPr txBox="1"/>
          <p:nvPr/>
        </p:nvSpPr>
        <p:spPr>
          <a:xfrm>
            <a:off x="1511490" y="295767"/>
            <a:ext cx="46025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*</a:t>
            </a:r>
          </a:p>
        </p:txBody>
      </p:sp>
      <p:grpSp>
        <p:nvGrpSpPr>
          <p:cNvPr id="48" name="Group 47">
            <a:extLst>
              <a:ext uri="{FF2B5EF4-FFF2-40B4-BE49-F238E27FC236}">
                <a16:creationId xmlns:a16="http://schemas.microsoft.com/office/drawing/2014/main" id="{AE4D80FD-E61A-DD5B-C74E-5287CAB4928C}"/>
              </a:ext>
            </a:extLst>
          </p:cNvPr>
          <p:cNvGrpSpPr/>
          <p:nvPr/>
        </p:nvGrpSpPr>
        <p:grpSpPr>
          <a:xfrm>
            <a:off x="764972" y="4060705"/>
            <a:ext cx="1371600" cy="1755257"/>
            <a:chOff x="764972" y="4060705"/>
            <a:chExt cx="1371600" cy="1755257"/>
          </a:xfrm>
        </p:grpSpPr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E90021D6-D44A-6907-56E8-26059156E41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/>
            <a:srcRect t="11434"/>
            <a:stretch/>
          </p:blipFill>
          <p:spPr>
            <a:xfrm>
              <a:off x="764972" y="4060705"/>
              <a:ext cx="1371600" cy="1755257"/>
            </a:xfrm>
            <a:prstGeom prst="rect">
              <a:avLst/>
            </a:prstGeom>
          </p:spPr>
        </p:pic>
        <p:cxnSp>
          <p:nvCxnSpPr>
            <p:cNvPr id="40" name="Straight Connector 39">
              <a:extLst>
                <a:ext uri="{FF2B5EF4-FFF2-40B4-BE49-F238E27FC236}">
                  <a16:creationId xmlns:a16="http://schemas.microsoft.com/office/drawing/2014/main" id="{F249D87C-5881-8F46-D675-23C5DE0395E7}"/>
                </a:ext>
              </a:extLst>
            </p:cNvPr>
            <p:cNvCxnSpPr/>
            <p:nvPr/>
          </p:nvCxnSpPr>
          <p:spPr>
            <a:xfrm>
              <a:off x="1505019" y="4280480"/>
              <a:ext cx="453789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117BB724-B15F-BF2D-6F73-8070216F648E}"/>
                </a:ext>
              </a:extLst>
            </p:cNvPr>
            <p:cNvSpPr txBox="1"/>
            <p:nvPr/>
          </p:nvSpPr>
          <p:spPr>
            <a:xfrm>
              <a:off x="1505020" y="4087110"/>
              <a:ext cx="4602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/>
                <a:t>*</a:t>
              </a:r>
            </a:p>
          </p:txBody>
        </p:sp>
      </p:grpSp>
      <p:pic>
        <p:nvPicPr>
          <p:cNvPr id="19" name="Picture 18">
            <a:extLst>
              <a:ext uri="{FF2B5EF4-FFF2-40B4-BE49-F238E27FC236}">
                <a16:creationId xmlns:a16="http://schemas.microsoft.com/office/drawing/2014/main" id="{9CC9F35D-CE6C-78E1-4B26-A08314A8848B}"/>
              </a:ext>
            </a:extLst>
          </p:cNvPr>
          <p:cNvPicPr>
            <a:picLocks noChangeAspect="1"/>
          </p:cNvPicPr>
          <p:nvPr/>
        </p:nvPicPr>
        <p:blipFill rotWithShape="1">
          <a:blip r:embed="rId15"/>
          <a:srcRect t="11434"/>
          <a:stretch/>
        </p:blipFill>
        <p:spPr>
          <a:xfrm>
            <a:off x="2322351" y="4068403"/>
            <a:ext cx="1371600" cy="1747559"/>
          </a:xfrm>
          <a:prstGeom prst="rect">
            <a:avLst/>
          </a:prstGeom>
        </p:spPr>
      </p:pic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9D2BB42C-808D-2490-B588-FFEBA04300DD}"/>
              </a:ext>
            </a:extLst>
          </p:cNvPr>
          <p:cNvCxnSpPr>
            <a:cxnSpLocks/>
          </p:cNvCxnSpPr>
          <p:nvPr/>
        </p:nvCxnSpPr>
        <p:spPr>
          <a:xfrm>
            <a:off x="2822813" y="4262990"/>
            <a:ext cx="23201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B4A3CF0D-0C93-D6B3-A2FA-B43E48362545}"/>
              </a:ext>
            </a:extLst>
          </p:cNvPr>
          <p:cNvSpPr txBox="1"/>
          <p:nvPr/>
        </p:nvSpPr>
        <p:spPr>
          <a:xfrm>
            <a:off x="2822812" y="4092389"/>
            <a:ext cx="228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*</a:t>
            </a:r>
          </a:p>
        </p:txBody>
      </p: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AF040B17-41AB-1C20-99CD-C10263F66AD8}"/>
              </a:ext>
            </a:extLst>
          </p:cNvPr>
          <p:cNvCxnSpPr>
            <a:cxnSpLocks/>
          </p:cNvCxnSpPr>
          <p:nvPr/>
        </p:nvCxnSpPr>
        <p:spPr>
          <a:xfrm>
            <a:off x="3073389" y="4262990"/>
            <a:ext cx="23201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1047D537-E429-96D7-21CF-FBBE16B46D1C}"/>
              </a:ext>
            </a:extLst>
          </p:cNvPr>
          <p:cNvSpPr txBox="1"/>
          <p:nvPr/>
        </p:nvSpPr>
        <p:spPr>
          <a:xfrm>
            <a:off x="2974153" y="4092389"/>
            <a:ext cx="43828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**</a:t>
            </a:r>
          </a:p>
        </p:txBody>
      </p: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886C15B7-B7A4-76A6-FAE1-18520A1FBDB0}"/>
              </a:ext>
            </a:extLst>
          </p:cNvPr>
          <p:cNvCxnSpPr/>
          <p:nvPr/>
        </p:nvCxnSpPr>
        <p:spPr>
          <a:xfrm>
            <a:off x="3065059" y="4152257"/>
            <a:ext cx="45378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8E97E996-C57D-E6A5-E030-667DA770037A}"/>
              </a:ext>
            </a:extLst>
          </p:cNvPr>
          <p:cNvSpPr txBox="1"/>
          <p:nvPr/>
        </p:nvSpPr>
        <p:spPr>
          <a:xfrm>
            <a:off x="3065060" y="3958887"/>
            <a:ext cx="46025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**</a:t>
            </a:r>
          </a:p>
        </p:txBody>
      </p:sp>
      <p:grpSp>
        <p:nvGrpSpPr>
          <p:cNvPr id="58" name="Group 57">
            <a:extLst>
              <a:ext uri="{FF2B5EF4-FFF2-40B4-BE49-F238E27FC236}">
                <a16:creationId xmlns:a16="http://schemas.microsoft.com/office/drawing/2014/main" id="{93D52E3D-78AF-8832-9E7C-29AEB70C6ABE}"/>
              </a:ext>
            </a:extLst>
          </p:cNvPr>
          <p:cNvGrpSpPr/>
          <p:nvPr/>
        </p:nvGrpSpPr>
        <p:grpSpPr>
          <a:xfrm>
            <a:off x="3879730" y="295767"/>
            <a:ext cx="1371600" cy="1862647"/>
            <a:chOff x="3879730" y="295767"/>
            <a:chExt cx="1371600" cy="1862647"/>
          </a:xfrm>
        </p:grpSpPr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71A5F971-E5F7-FA5C-F929-3C736D835F1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/>
            <a:srcRect t="11434"/>
            <a:stretch/>
          </p:blipFill>
          <p:spPr>
            <a:xfrm>
              <a:off x="3879730" y="418487"/>
              <a:ext cx="1371600" cy="1739927"/>
            </a:xfrm>
            <a:prstGeom prst="rect">
              <a:avLst/>
            </a:prstGeom>
          </p:spPr>
        </p:pic>
        <p:cxnSp>
          <p:nvCxnSpPr>
            <p:cNvPr id="52" name="Straight Connector 51">
              <a:extLst>
                <a:ext uri="{FF2B5EF4-FFF2-40B4-BE49-F238E27FC236}">
                  <a16:creationId xmlns:a16="http://schemas.microsoft.com/office/drawing/2014/main" id="{B795A290-5F53-83E0-DDD2-378D32DC6B02}"/>
                </a:ext>
              </a:extLst>
            </p:cNvPr>
            <p:cNvCxnSpPr>
              <a:cxnSpLocks/>
            </p:cNvCxnSpPr>
            <p:nvPr/>
          </p:nvCxnSpPr>
          <p:spPr>
            <a:xfrm>
              <a:off x="4379979" y="677838"/>
              <a:ext cx="23201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12C2A811-2AD1-CF94-CD8E-FE27E507864B}"/>
                </a:ext>
              </a:extLst>
            </p:cNvPr>
            <p:cNvSpPr txBox="1"/>
            <p:nvPr/>
          </p:nvSpPr>
          <p:spPr>
            <a:xfrm>
              <a:off x="4312670" y="470845"/>
              <a:ext cx="36678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/>
                <a:t>**</a:t>
              </a:r>
            </a:p>
          </p:txBody>
        </p:sp>
        <p:cxnSp>
          <p:nvCxnSpPr>
            <p:cNvPr id="54" name="Straight Connector 53">
              <a:extLst>
                <a:ext uri="{FF2B5EF4-FFF2-40B4-BE49-F238E27FC236}">
                  <a16:creationId xmlns:a16="http://schemas.microsoft.com/office/drawing/2014/main" id="{F7E1F6BB-E2F6-97A4-23C7-9F9F9AEFD4A9}"/>
                </a:ext>
              </a:extLst>
            </p:cNvPr>
            <p:cNvCxnSpPr>
              <a:cxnSpLocks/>
            </p:cNvCxnSpPr>
            <p:nvPr/>
          </p:nvCxnSpPr>
          <p:spPr>
            <a:xfrm>
              <a:off x="4630555" y="677838"/>
              <a:ext cx="23201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96492021-CF25-E69F-8D72-B7436CBB3DFC}"/>
                </a:ext>
              </a:extLst>
            </p:cNvPr>
            <p:cNvSpPr txBox="1"/>
            <p:nvPr/>
          </p:nvSpPr>
          <p:spPr>
            <a:xfrm>
              <a:off x="4630554" y="470845"/>
              <a:ext cx="2286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/>
                <a:t>*</a:t>
              </a:r>
            </a:p>
          </p:txBody>
        </p:sp>
        <p:cxnSp>
          <p:nvCxnSpPr>
            <p:cNvPr id="56" name="Straight Connector 55">
              <a:extLst>
                <a:ext uri="{FF2B5EF4-FFF2-40B4-BE49-F238E27FC236}">
                  <a16:creationId xmlns:a16="http://schemas.microsoft.com/office/drawing/2014/main" id="{EB275790-1E74-6C33-109E-5E0A6907A4F8}"/>
                </a:ext>
              </a:extLst>
            </p:cNvPr>
            <p:cNvCxnSpPr/>
            <p:nvPr/>
          </p:nvCxnSpPr>
          <p:spPr>
            <a:xfrm>
              <a:off x="4608578" y="489137"/>
              <a:ext cx="453789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D4A6D608-BB1E-EF63-5B23-1C1A8BDD39AA}"/>
                </a:ext>
              </a:extLst>
            </p:cNvPr>
            <p:cNvSpPr txBox="1"/>
            <p:nvPr/>
          </p:nvSpPr>
          <p:spPr>
            <a:xfrm>
              <a:off x="4608579" y="295767"/>
              <a:ext cx="4602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/>
                <a:t>*</a:t>
              </a:r>
            </a:p>
          </p:txBody>
        </p:sp>
      </p:grp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16CC6162-6247-EA86-42FF-04D1F074B3B4}"/>
              </a:ext>
            </a:extLst>
          </p:cNvPr>
          <p:cNvCxnSpPr>
            <a:cxnSpLocks/>
          </p:cNvCxnSpPr>
          <p:nvPr/>
        </p:nvCxnSpPr>
        <p:spPr>
          <a:xfrm>
            <a:off x="4431548" y="4388630"/>
            <a:ext cx="23201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0" name="TextBox 59">
            <a:extLst>
              <a:ext uri="{FF2B5EF4-FFF2-40B4-BE49-F238E27FC236}">
                <a16:creationId xmlns:a16="http://schemas.microsoft.com/office/drawing/2014/main" id="{3F874B64-973C-5393-CA8A-7988CDF39C97}"/>
              </a:ext>
            </a:extLst>
          </p:cNvPr>
          <p:cNvSpPr txBox="1"/>
          <p:nvPr/>
        </p:nvSpPr>
        <p:spPr>
          <a:xfrm>
            <a:off x="4353072" y="4181637"/>
            <a:ext cx="3794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**</a:t>
            </a:r>
          </a:p>
        </p:txBody>
      </p: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8391F256-9B20-F90C-234F-06973DE717DE}"/>
              </a:ext>
            </a:extLst>
          </p:cNvPr>
          <p:cNvCxnSpPr>
            <a:cxnSpLocks/>
          </p:cNvCxnSpPr>
          <p:nvPr/>
        </p:nvCxnSpPr>
        <p:spPr>
          <a:xfrm>
            <a:off x="4676336" y="4388630"/>
            <a:ext cx="23201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2" name="TextBox 61">
            <a:extLst>
              <a:ext uri="{FF2B5EF4-FFF2-40B4-BE49-F238E27FC236}">
                <a16:creationId xmlns:a16="http://schemas.microsoft.com/office/drawing/2014/main" id="{963D7FD4-3F65-1452-6A87-35CBAAC8E97F}"/>
              </a:ext>
            </a:extLst>
          </p:cNvPr>
          <p:cNvSpPr txBox="1"/>
          <p:nvPr/>
        </p:nvSpPr>
        <p:spPr>
          <a:xfrm>
            <a:off x="4533941" y="4181919"/>
            <a:ext cx="5167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***</a:t>
            </a:r>
          </a:p>
        </p:txBody>
      </p:sp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00AB3656-0BD2-4474-786A-DB606D2CDFC9}"/>
              </a:ext>
            </a:extLst>
          </p:cNvPr>
          <p:cNvCxnSpPr/>
          <p:nvPr/>
        </p:nvCxnSpPr>
        <p:spPr>
          <a:xfrm>
            <a:off x="4647447" y="4199929"/>
            <a:ext cx="45378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4" name="TextBox 63">
            <a:extLst>
              <a:ext uri="{FF2B5EF4-FFF2-40B4-BE49-F238E27FC236}">
                <a16:creationId xmlns:a16="http://schemas.microsoft.com/office/drawing/2014/main" id="{F5E9C5E8-9536-1DCC-9CAB-37719E9785A6}"/>
              </a:ext>
            </a:extLst>
          </p:cNvPr>
          <p:cNvSpPr txBox="1"/>
          <p:nvPr/>
        </p:nvSpPr>
        <p:spPr>
          <a:xfrm>
            <a:off x="4647448" y="4006559"/>
            <a:ext cx="46025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**</a:t>
            </a:r>
          </a:p>
        </p:txBody>
      </p: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E318D6AF-E299-79D1-6E3D-E0B5D2C99027}"/>
              </a:ext>
            </a:extLst>
          </p:cNvPr>
          <p:cNvCxnSpPr>
            <a:cxnSpLocks/>
          </p:cNvCxnSpPr>
          <p:nvPr/>
        </p:nvCxnSpPr>
        <p:spPr>
          <a:xfrm>
            <a:off x="5927721" y="485083"/>
            <a:ext cx="23201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6" name="TextBox 75">
            <a:extLst>
              <a:ext uri="{FF2B5EF4-FFF2-40B4-BE49-F238E27FC236}">
                <a16:creationId xmlns:a16="http://schemas.microsoft.com/office/drawing/2014/main" id="{8D10AD44-BC61-3E06-A5EB-9640F0492256}"/>
              </a:ext>
            </a:extLst>
          </p:cNvPr>
          <p:cNvSpPr txBox="1"/>
          <p:nvPr/>
        </p:nvSpPr>
        <p:spPr>
          <a:xfrm>
            <a:off x="5927720" y="311110"/>
            <a:ext cx="228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*</a:t>
            </a:r>
          </a:p>
        </p:txBody>
      </p:sp>
      <p:cxnSp>
        <p:nvCxnSpPr>
          <p:cNvPr id="77" name="Straight Connector 76">
            <a:extLst>
              <a:ext uri="{FF2B5EF4-FFF2-40B4-BE49-F238E27FC236}">
                <a16:creationId xmlns:a16="http://schemas.microsoft.com/office/drawing/2014/main" id="{243D8859-9406-DE5A-94D8-19DD61D7FA81}"/>
              </a:ext>
            </a:extLst>
          </p:cNvPr>
          <p:cNvCxnSpPr>
            <a:cxnSpLocks/>
          </p:cNvCxnSpPr>
          <p:nvPr/>
        </p:nvCxnSpPr>
        <p:spPr>
          <a:xfrm>
            <a:off x="6178297" y="485083"/>
            <a:ext cx="23201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8" name="TextBox 77">
            <a:extLst>
              <a:ext uri="{FF2B5EF4-FFF2-40B4-BE49-F238E27FC236}">
                <a16:creationId xmlns:a16="http://schemas.microsoft.com/office/drawing/2014/main" id="{A8D4CE0B-20E2-122B-ACBD-1E5EBC95D82A}"/>
              </a:ext>
            </a:extLst>
          </p:cNvPr>
          <p:cNvSpPr txBox="1"/>
          <p:nvPr/>
        </p:nvSpPr>
        <p:spPr>
          <a:xfrm>
            <a:off x="6178296" y="311110"/>
            <a:ext cx="228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*</a:t>
            </a:r>
          </a:p>
        </p:txBody>
      </p:sp>
      <p:cxnSp>
        <p:nvCxnSpPr>
          <p:cNvPr id="79" name="Straight Connector 78">
            <a:extLst>
              <a:ext uri="{FF2B5EF4-FFF2-40B4-BE49-F238E27FC236}">
                <a16:creationId xmlns:a16="http://schemas.microsoft.com/office/drawing/2014/main" id="{BB4ECEC1-6534-5F45-46C2-64BD1C311E6D}"/>
              </a:ext>
            </a:extLst>
          </p:cNvPr>
          <p:cNvCxnSpPr/>
          <p:nvPr/>
        </p:nvCxnSpPr>
        <p:spPr>
          <a:xfrm>
            <a:off x="6156320" y="380202"/>
            <a:ext cx="45378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0" name="TextBox 79">
            <a:extLst>
              <a:ext uri="{FF2B5EF4-FFF2-40B4-BE49-F238E27FC236}">
                <a16:creationId xmlns:a16="http://schemas.microsoft.com/office/drawing/2014/main" id="{8311CA72-17AE-0F9F-AD24-36451880BF99}"/>
              </a:ext>
            </a:extLst>
          </p:cNvPr>
          <p:cNvSpPr txBox="1"/>
          <p:nvPr/>
        </p:nvSpPr>
        <p:spPr>
          <a:xfrm>
            <a:off x="6156321" y="212232"/>
            <a:ext cx="46025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*</a:t>
            </a:r>
          </a:p>
        </p:txBody>
      </p:sp>
      <p:cxnSp>
        <p:nvCxnSpPr>
          <p:cNvPr id="81" name="Straight Connector 80">
            <a:extLst>
              <a:ext uri="{FF2B5EF4-FFF2-40B4-BE49-F238E27FC236}">
                <a16:creationId xmlns:a16="http://schemas.microsoft.com/office/drawing/2014/main" id="{FAE26C7F-8515-FC27-C4BD-DA0DBDC0F0DC}"/>
              </a:ext>
            </a:extLst>
          </p:cNvPr>
          <p:cNvCxnSpPr>
            <a:cxnSpLocks/>
          </p:cNvCxnSpPr>
          <p:nvPr/>
        </p:nvCxnSpPr>
        <p:spPr>
          <a:xfrm>
            <a:off x="6399277" y="1246848"/>
            <a:ext cx="23201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2" name="TextBox 81">
            <a:extLst>
              <a:ext uri="{FF2B5EF4-FFF2-40B4-BE49-F238E27FC236}">
                <a16:creationId xmlns:a16="http://schemas.microsoft.com/office/drawing/2014/main" id="{0EB172C3-39DC-733E-1280-3BD74694A2E8}"/>
              </a:ext>
            </a:extLst>
          </p:cNvPr>
          <p:cNvSpPr txBox="1"/>
          <p:nvPr/>
        </p:nvSpPr>
        <p:spPr>
          <a:xfrm>
            <a:off x="6399276" y="1039855"/>
            <a:ext cx="228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*</a:t>
            </a:r>
          </a:p>
        </p:txBody>
      </p:sp>
      <p:cxnSp>
        <p:nvCxnSpPr>
          <p:cNvPr id="83" name="Straight Connector 82">
            <a:extLst>
              <a:ext uri="{FF2B5EF4-FFF2-40B4-BE49-F238E27FC236}">
                <a16:creationId xmlns:a16="http://schemas.microsoft.com/office/drawing/2014/main" id="{1DE0B531-C36A-2747-8E5B-4F0E92F8971A}"/>
              </a:ext>
            </a:extLst>
          </p:cNvPr>
          <p:cNvCxnSpPr>
            <a:cxnSpLocks/>
          </p:cNvCxnSpPr>
          <p:nvPr/>
        </p:nvCxnSpPr>
        <p:spPr>
          <a:xfrm>
            <a:off x="5954258" y="4339387"/>
            <a:ext cx="23201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4" name="TextBox 83">
            <a:extLst>
              <a:ext uri="{FF2B5EF4-FFF2-40B4-BE49-F238E27FC236}">
                <a16:creationId xmlns:a16="http://schemas.microsoft.com/office/drawing/2014/main" id="{772AB8A3-371A-6C68-6A9E-BA2BC05DC688}"/>
              </a:ext>
            </a:extLst>
          </p:cNvPr>
          <p:cNvSpPr txBox="1"/>
          <p:nvPr/>
        </p:nvSpPr>
        <p:spPr>
          <a:xfrm>
            <a:off x="5865898" y="4142114"/>
            <a:ext cx="4143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**</a:t>
            </a:r>
          </a:p>
        </p:txBody>
      </p:sp>
      <p:cxnSp>
        <p:nvCxnSpPr>
          <p:cNvPr id="85" name="Straight Connector 84">
            <a:extLst>
              <a:ext uri="{FF2B5EF4-FFF2-40B4-BE49-F238E27FC236}">
                <a16:creationId xmlns:a16="http://schemas.microsoft.com/office/drawing/2014/main" id="{ECA3381C-5D9E-CDDB-E261-C152E8C68D41}"/>
              </a:ext>
            </a:extLst>
          </p:cNvPr>
          <p:cNvCxnSpPr>
            <a:cxnSpLocks/>
          </p:cNvCxnSpPr>
          <p:nvPr/>
        </p:nvCxnSpPr>
        <p:spPr>
          <a:xfrm>
            <a:off x="6204834" y="4339387"/>
            <a:ext cx="23201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6" name="TextBox 85">
            <a:extLst>
              <a:ext uri="{FF2B5EF4-FFF2-40B4-BE49-F238E27FC236}">
                <a16:creationId xmlns:a16="http://schemas.microsoft.com/office/drawing/2014/main" id="{8E906745-2EB3-13D9-9EE1-779D3514925B}"/>
              </a:ext>
            </a:extLst>
          </p:cNvPr>
          <p:cNvSpPr txBox="1"/>
          <p:nvPr/>
        </p:nvSpPr>
        <p:spPr>
          <a:xfrm>
            <a:off x="5966038" y="4142455"/>
            <a:ext cx="72718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***</a:t>
            </a:r>
          </a:p>
        </p:txBody>
      </p:sp>
      <p:cxnSp>
        <p:nvCxnSpPr>
          <p:cNvPr id="87" name="Straight Connector 86">
            <a:extLst>
              <a:ext uri="{FF2B5EF4-FFF2-40B4-BE49-F238E27FC236}">
                <a16:creationId xmlns:a16="http://schemas.microsoft.com/office/drawing/2014/main" id="{D87BD41C-973B-A09D-0DFC-2481D5F5B3B8}"/>
              </a:ext>
            </a:extLst>
          </p:cNvPr>
          <p:cNvCxnSpPr/>
          <p:nvPr/>
        </p:nvCxnSpPr>
        <p:spPr>
          <a:xfrm>
            <a:off x="6182857" y="4150686"/>
            <a:ext cx="45378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8" name="TextBox 87">
            <a:extLst>
              <a:ext uri="{FF2B5EF4-FFF2-40B4-BE49-F238E27FC236}">
                <a16:creationId xmlns:a16="http://schemas.microsoft.com/office/drawing/2014/main" id="{C2F17E30-6CCF-A34E-F11E-8DE8BBC08D14}"/>
              </a:ext>
            </a:extLst>
          </p:cNvPr>
          <p:cNvSpPr txBox="1"/>
          <p:nvPr/>
        </p:nvSpPr>
        <p:spPr>
          <a:xfrm>
            <a:off x="6182858" y="3957316"/>
            <a:ext cx="46025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*</a:t>
            </a:r>
          </a:p>
        </p:txBody>
      </p:sp>
      <p:cxnSp>
        <p:nvCxnSpPr>
          <p:cNvPr id="95" name="Straight Connector 94">
            <a:extLst>
              <a:ext uri="{FF2B5EF4-FFF2-40B4-BE49-F238E27FC236}">
                <a16:creationId xmlns:a16="http://schemas.microsoft.com/office/drawing/2014/main" id="{5D17CCA7-0695-6FD6-8E5B-565FA293225D}"/>
              </a:ext>
            </a:extLst>
          </p:cNvPr>
          <p:cNvCxnSpPr>
            <a:cxnSpLocks/>
          </p:cNvCxnSpPr>
          <p:nvPr/>
        </p:nvCxnSpPr>
        <p:spPr>
          <a:xfrm>
            <a:off x="7551115" y="4318047"/>
            <a:ext cx="23201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6" name="TextBox 95">
            <a:extLst>
              <a:ext uri="{FF2B5EF4-FFF2-40B4-BE49-F238E27FC236}">
                <a16:creationId xmlns:a16="http://schemas.microsoft.com/office/drawing/2014/main" id="{B8EA3B15-D760-20E2-38DB-A784F528F15E}"/>
              </a:ext>
            </a:extLst>
          </p:cNvPr>
          <p:cNvSpPr txBox="1"/>
          <p:nvPr/>
        </p:nvSpPr>
        <p:spPr>
          <a:xfrm>
            <a:off x="7551114" y="4111054"/>
            <a:ext cx="228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*</a:t>
            </a:r>
          </a:p>
        </p:txBody>
      </p:sp>
      <p:cxnSp>
        <p:nvCxnSpPr>
          <p:cNvPr id="97" name="Straight Connector 96">
            <a:extLst>
              <a:ext uri="{FF2B5EF4-FFF2-40B4-BE49-F238E27FC236}">
                <a16:creationId xmlns:a16="http://schemas.microsoft.com/office/drawing/2014/main" id="{18AEDEFD-451D-EA42-EFD3-E4C4F1527C74}"/>
              </a:ext>
            </a:extLst>
          </p:cNvPr>
          <p:cNvCxnSpPr>
            <a:cxnSpLocks/>
          </p:cNvCxnSpPr>
          <p:nvPr/>
        </p:nvCxnSpPr>
        <p:spPr>
          <a:xfrm>
            <a:off x="7801691" y="4318047"/>
            <a:ext cx="23201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8" name="TextBox 97">
            <a:extLst>
              <a:ext uri="{FF2B5EF4-FFF2-40B4-BE49-F238E27FC236}">
                <a16:creationId xmlns:a16="http://schemas.microsoft.com/office/drawing/2014/main" id="{EFA20CCB-D4C0-0F2E-CB8C-A847DAC1BF13}"/>
              </a:ext>
            </a:extLst>
          </p:cNvPr>
          <p:cNvSpPr txBox="1"/>
          <p:nvPr/>
        </p:nvSpPr>
        <p:spPr>
          <a:xfrm>
            <a:off x="7801690" y="4111054"/>
            <a:ext cx="228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*</a:t>
            </a:r>
          </a:p>
        </p:txBody>
      </p:sp>
      <p:cxnSp>
        <p:nvCxnSpPr>
          <p:cNvPr id="99" name="Straight Connector 98">
            <a:extLst>
              <a:ext uri="{FF2B5EF4-FFF2-40B4-BE49-F238E27FC236}">
                <a16:creationId xmlns:a16="http://schemas.microsoft.com/office/drawing/2014/main" id="{2CEE4A45-9053-38CC-EE66-72B1CE023C1A}"/>
              </a:ext>
            </a:extLst>
          </p:cNvPr>
          <p:cNvCxnSpPr/>
          <p:nvPr/>
        </p:nvCxnSpPr>
        <p:spPr>
          <a:xfrm>
            <a:off x="7779714" y="4148396"/>
            <a:ext cx="45378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0" name="TextBox 99">
            <a:extLst>
              <a:ext uri="{FF2B5EF4-FFF2-40B4-BE49-F238E27FC236}">
                <a16:creationId xmlns:a16="http://schemas.microsoft.com/office/drawing/2014/main" id="{72A602D9-59FD-099E-CF46-7AFF83C03B49}"/>
              </a:ext>
            </a:extLst>
          </p:cNvPr>
          <p:cNvSpPr txBox="1"/>
          <p:nvPr/>
        </p:nvSpPr>
        <p:spPr>
          <a:xfrm>
            <a:off x="7779715" y="3955026"/>
            <a:ext cx="46025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42584548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59</TotalTime>
  <Words>1036</Words>
  <Application>Microsoft Office PowerPoint</Application>
  <PresentationFormat>On-screen Show (4:3)</PresentationFormat>
  <Paragraphs>555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4" baseType="lpstr">
      <vt:lpstr>Arial</vt:lpstr>
      <vt:lpstr>Calibri</vt:lpstr>
      <vt:lpstr>Calibri Light</vt:lpstr>
      <vt:lpstr>Palatino Linotype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rene soleto fernandez</dc:creator>
  <cp:lastModifiedBy>MDPI</cp:lastModifiedBy>
  <cp:revision>66</cp:revision>
  <dcterms:created xsi:type="dcterms:W3CDTF">2022-01-04T09:16:41Z</dcterms:created>
  <dcterms:modified xsi:type="dcterms:W3CDTF">2022-08-04T10:09:51Z</dcterms:modified>
</cp:coreProperties>
</file>